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308" r:id="rId2"/>
    <p:sldId id="301" r:id="rId3"/>
    <p:sldId id="309" r:id="rId4"/>
    <p:sldId id="266" r:id="rId5"/>
    <p:sldId id="310" r:id="rId6"/>
    <p:sldId id="31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915"/>
  </p:normalViewPr>
  <p:slideViewPr>
    <p:cSldViewPr snapToGrid="0" snapToObjects="1">
      <p:cViewPr varScale="1">
        <p:scale>
          <a:sx n="107" d="100"/>
          <a:sy n="107" d="100"/>
        </p:scale>
        <p:origin x="13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ACF05A-C02B-B34F-9616-29E7CFF9053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0622A5-79E4-DF44-8E9D-3396FB4448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9152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u="non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2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on targeted array data indicating reduced hybridization for exon 2 probes. Control sample shows Exon 2 probes clustering around Log2 ratio of 0 indicating normal copy number. Case 10 and case 1 show progressively less exon 2 probe binding indicative of heterozygous and homozygous deletion of exon 2, respectively.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C22E9-B157-9941-9CBC-5F0A8E64BF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5745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Figure 1, Sanger sequencing confirmation of </a:t>
            </a:r>
            <a:r>
              <a:rPr lang="en-US" b="1" i="1" dirty="0"/>
              <a:t>DBT</a:t>
            </a:r>
            <a:r>
              <a:rPr lang="en-US" b="1" dirty="0"/>
              <a:t> delEx2</a:t>
            </a:r>
            <a:r>
              <a:rPr lang="en-US" b="1" i="1" dirty="0"/>
              <a:t> </a:t>
            </a:r>
            <a:r>
              <a:rPr lang="en-US" b="1" dirty="0"/>
              <a:t>variant detected by next generation sequencing. </a:t>
            </a:r>
          </a:p>
          <a:p>
            <a:pPr marL="228600" indent="-228600">
              <a:buAutoNum type="alphaUcParenR"/>
            </a:pPr>
            <a:endParaRPr lang="en-US" b="0" dirty="0"/>
          </a:p>
          <a:p>
            <a:pPr marL="228600" indent="-228600">
              <a:buAutoNum type="alphaUcParenR"/>
            </a:pPr>
            <a:r>
              <a:rPr lang="en-US" b="0" dirty="0"/>
              <a:t>Sanger sequencing confirms the deletion of exon 2 in Case 7. A 7bp area of homology with intron 1 and intron 2 is detected on either side of the roughly 7.4kb deletion.</a:t>
            </a:r>
          </a:p>
          <a:p>
            <a:pPr marL="228600" indent="-228600">
              <a:buAutoNum type="alphaUcParenR"/>
            </a:pPr>
            <a:endParaRPr lang="en-US" b="0" dirty="0"/>
          </a:p>
          <a:p>
            <a:pPr marL="228600" indent="-228600">
              <a:buAutoNum type="alphaUcParenR"/>
            </a:pPr>
            <a:r>
              <a:rPr lang="en-US" b="0" dirty="0"/>
              <a:t>Schematic of primer design utilized for confirmation of exon 2 deletion with primer sequences. For sequencing, PCR 3 has M13F and M13R tails; M13 sequences not shown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C22E9-B157-9941-9CBC-5F0A8E64BFD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8607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3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rental testing to determine phase indicates c.916T&gt;C in trans with deletion of exon 2 in Case 10. Sanger sequencing of Case 10 and his mother and exon targeted array for Case 10 and his father are shown indicating inheritance of each variant from a separate parent. For Sanger sequencing, the following primers were used:</a:t>
            </a:r>
          </a:p>
          <a:p>
            <a:pPr rtl="0" eaLnBrk="1" fontAlgn="t" latinLnBrk="0" hangingPunct="1"/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ward = CATATTGCATGTTGGCAAAGCAA</a:t>
            </a:r>
          </a:p>
          <a:p>
            <a:pPr rtl="0" eaLnBrk="1" fontAlgn="t" latinLnBrk="0" hangingPunct="1"/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verse = CAGCCCTGAAGATACCTCATTTTGG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C22E9-B157-9941-9CBC-5F0A8E64BFD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2155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ure 4, Possible area of identity by descent: </a:t>
            </a:r>
            <a:endParaRPr lang="en-US" dirty="0"/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Chromosomal microarray analysis of Case 5 indicates a region of homozygosity surrounding th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B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ocus. Depicted is a B allele Frequency plot of SNP microarray data. There is a ~15 Mb area of homozygosity (AOH) surrounding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B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uggestive of a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plotyp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lock with identity by descent between both copies of this area of chromosome 1.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) </a:t>
            </a:r>
            <a:r>
              <a:rPr lang="en-US" dirty="0"/>
              <a:t>A genotype concordance plot from residual exome data from Case 7 and Case 8, who are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mpound heterozygous for delEx2 and c.916T&gt;C in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B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dirty="0"/>
              <a:t>Calls as reference or variant by position were graphed to show concordant and discordant genotypes between the two cases. There is a ~15Mb region (green shading) around </a:t>
            </a:r>
            <a:r>
              <a:rPr lang="en-US" i="1" dirty="0"/>
              <a:t>DBT </a:t>
            </a:r>
            <a:r>
              <a:rPr lang="en-US" dirty="0"/>
              <a:t>(dashed line) where there are no apparent discrepancies between the calls, suggesting an inherite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plotyp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lock for these two cases who are not known to be related. The AOH seen in case 5 is depicted with the flanking dashed lin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C22E9-B157-9941-9CBC-5F0A8E64BFD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13844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5.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anched-chain amino acid analysis via dried blood spot at time points 0, 30, 90, 180, and 300 minutes following a 70 mg/kg isoleucine bolus at baseline and repeated after &gt;1 week of thiamine supplementation (B1, 100mg).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) A significant reduction in the isoleucine level was not appreciated status post thiamine for cases 7 &amp; 9 who are compound heterozygous for delEx2 and c.916T&gt;C in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B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) A significant reduction in the isoleucine level was not appreciated status post thiamine for case 12 who is homozygous for c.1261G&gt;T in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B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C22E9-B157-9941-9CBC-5F0A8E64BFD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67913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6A) Sketch of HemoShear Therapeutics’ hepatocyte bio-reactor. Medium is infused from the infusion port and goes through the upper chamber with the cone (orange triangle which spins) providing for down-ward force on the apical side of the hepatocytes in addition to perfusion through the lower chamber providing horizontal force along the basal side of the hepatocytes. Out-flow is collected by the transport outflow. In these studies, cells are exposed to normal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patocel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dium as well as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patocel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edium enhanced with additional 5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eucine, 5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soleucine, and 5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aline to recapitulate a decompensation even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C22E9-B157-9941-9CBC-5F0A8E64BFD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960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A41A3-CABA-8DB1-03C4-C39FD1F24D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17609E-E2F3-20EC-3C4F-C43E930C55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873B05-DBEF-53C3-CF2A-C62A6E78D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9DB1F9-53E6-B7AB-D222-8AFE60BFC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26E21C-4FAF-0DBF-A010-6A94D4A77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276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8F810-6493-85EF-1B57-4CFC13BD1C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10B037-3BD7-7A5B-BDB7-344CF6DB67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E9706C-6596-64DC-5AFE-EEAFE058D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AB49E0-5646-47B2-340F-FAC6FA704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A84F9A-50B8-7D3F-2B07-0979ED1A2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853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19C4DE0-6609-1BD1-ED3E-D4D8EBAB30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4AC110-6ABE-02CB-E228-7AF7A696E7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A443E1-7C23-EA58-E5DA-0595FF2D1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B8CCB0-7413-F953-DAB3-374B99A94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8E8912-78A8-A73A-B50E-04FD8E162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563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494B19-D784-B85D-8FD2-BB77FEA0B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CEE02CE-BCD5-AD40-851F-97937BF377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BDDA3-3E63-9EA0-EAE4-BA33911A3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18EA6B-A137-DD3D-6ACE-68C17013B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023FF-8C75-467E-F171-3997EE7A8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36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36CB70-3C83-E3AC-AEBC-1E41597608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D8C7C4-6BE9-72A4-04ED-289A22161D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FC160E-5D7A-0318-C795-E11E4DE81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753B5B-4759-C87D-FB70-10FF9F84F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3AC372-F773-E89F-6B02-BD6FD483C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643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E11B4-1DA8-02DC-21A5-C369E5316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1B764D-B9A7-44A1-BFD3-4FC5E89B49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BDA6DC-B0DE-32C6-D070-9CBD23CC91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9DBF6B-D96F-0DB7-280E-4A4B3860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ACF840-882E-9B49-474F-E517A6269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E587A2-E63F-B431-1557-459CBBDF69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7491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BE9D0-3EF4-096C-AEEB-DB7ACDD35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9A26A5-442A-1553-593F-6E42454D99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FE368D-1BC0-C8A5-0D75-56CFB60C93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D09E43-7F5B-73B5-3261-2F8D8CFBC5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0A6FED-BED6-EEB2-4D64-F46D83F736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46F08D-926F-428B-0B4E-177335E61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0DFD3E-B058-8393-8575-5D8A30449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08613D5-48B3-575E-EC9D-E715BBB96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282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C996B-7527-83FB-BA8D-195B8C482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1A6CD4-1885-0ED2-F400-92DB782F2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69A8BD-924A-33FC-93F8-E509CFC48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425B5E-4119-9421-1BAF-CCC2C5A1A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727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FA8063-A28D-8790-798E-5B116067A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EA8E32-6E89-7FA8-6C34-F47C23768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BDF76F6-2649-E0DD-89F8-AE9D19E9AA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66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5F8DA-8120-6523-3A74-DF9638A6EA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4C7F89-E70A-95D5-A2D3-43531A1BB2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B534A7-9E18-D11E-C5A8-DDA318137A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B89B8A-D99F-369A-CE64-7E0F2FC3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039B21-D845-02A0-50E8-AD8ABAF5F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F97561-DDD5-474A-3DB4-39870B8CF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202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6FE6D-7C32-D5E9-517F-4C81F7A178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1CF44B-D2AD-79DC-C68F-DD05984CA4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962C77-71EB-3730-0EFC-A7227505E8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9C9588-6D0D-80D6-2ADC-9FB2EC391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3980E1-1ACB-6202-333C-1C3670080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890D95-61CA-EE1D-8694-C6764C3E4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700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CACD1B-795B-401B-CA6F-7F4ADC9E38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2E22AF-5D13-7F86-0DBD-0FB322B23E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FA239-2DC9-9A08-27F7-0F458F3881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0828B-F8B7-4B4D-8795-70D3E7E7BF92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EDDA8E-3D08-0890-D1EE-B8BC79BF74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B4D13F-3D64-E412-18D5-E9AC209B0A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5B616-2497-F043-A71F-11BC3E217B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635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290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11.png"/><Relationship Id="rId7" Type="http://schemas.microsoft.com/office/2007/relationships/hdphoto" Target="../media/hdphoto3.wdp"/><Relationship Id="rId12" Type="http://schemas.openxmlformats.org/officeDocument/2006/relationships/image" Target="../media/image16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11" Type="http://schemas.openxmlformats.org/officeDocument/2006/relationships/image" Target="../media/image15.tiff"/><Relationship Id="rId5" Type="http://schemas.microsoft.com/office/2007/relationships/hdphoto" Target="../media/hdphoto2.wdp"/><Relationship Id="rId10" Type="http://schemas.openxmlformats.org/officeDocument/2006/relationships/image" Target="../media/image14.tiff"/><Relationship Id="rId4" Type="http://schemas.microsoft.com/office/2007/relationships/hdphoto" Target="../media/hdphoto1.wdp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A8196F33-7594-9546-A8A6-61B9AEAF232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35" t="1007" b="32349"/>
          <a:stretch/>
        </p:blipFill>
        <p:spPr>
          <a:xfrm flipH="1">
            <a:off x="583091" y="795130"/>
            <a:ext cx="10775189" cy="34219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6D916F3-23A4-EC4F-A648-57307C2D325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76" t="87666" b="5133"/>
          <a:stretch/>
        </p:blipFill>
        <p:spPr>
          <a:xfrm flipH="1">
            <a:off x="583094" y="4351872"/>
            <a:ext cx="10781746" cy="369746"/>
          </a:xfrm>
          <a:prstGeom prst="rect">
            <a:avLst/>
          </a:prstGeom>
        </p:spPr>
      </p:pic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A6D5B87-90C2-E44C-9819-F45006B06136}"/>
              </a:ext>
            </a:extLst>
          </p:cNvPr>
          <p:cNvCxnSpPr>
            <a:cxnSpLocks/>
          </p:cNvCxnSpPr>
          <p:nvPr/>
        </p:nvCxnSpPr>
        <p:spPr>
          <a:xfrm>
            <a:off x="869944" y="4926011"/>
            <a:ext cx="10517198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A2C37253-D556-1741-B132-2A981DDA9522}"/>
              </a:ext>
            </a:extLst>
          </p:cNvPr>
          <p:cNvCxnSpPr>
            <a:cxnSpLocks/>
          </p:cNvCxnSpPr>
          <p:nvPr/>
        </p:nvCxnSpPr>
        <p:spPr>
          <a:xfrm>
            <a:off x="812844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2C55F51-10B3-664B-BDA5-E7AB52F2E980}"/>
              </a:ext>
            </a:extLst>
          </p:cNvPr>
          <p:cNvCxnSpPr>
            <a:cxnSpLocks/>
          </p:cNvCxnSpPr>
          <p:nvPr/>
        </p:nvCxnSpPr>
        <p:spPr>
          <a:xfrm>
            <a:off x="494661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09DF7B9D-8773-DF41-B9DA-3026C56F7A2E}"/>
              </a:ext>
            </a:extLst>
          </p:cNvPr>
          <p:cNvCxnSpPr>
            <a:cxnSpLocks/>
          </p:cNvCxnSpPr>
          <p:nvPr/>
        </p:nvCxnSpPr>
        <p:spPr>
          <a:xfrm>
            <a:off x="600722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9E2C17D-376B-D849-920E-58F3914F00B6}"/>
              </a:ext>
            </a:extLst>
          </p:cNvPr>
          <p:cNvCxnSpPr>
            <a:cxnSpLocks/>
          </p:cNvCxnSpPr>
          <p:nvPr/>
        </p:nvCxnSpPr>
        <p:spPr>
          <a:xfrm>
            <a:off x="918905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ED3C4C83-F98E-8E48-861C-8478F2B95529}"/>
              </a:ext>
            </a:extLst>
          </p:cNvPr>
          <p:cNvCxnSpPr>
            <a:cxnSpLocks/>
          </p:cNvCxnSpPr>
          <p:nvPr/>
        </p:nvCxnSpPr>
        <p:spPr>
          <a:xfrm>
            <a:off x="1131027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9BF9D34-2554-AB42-AB45-C42D52F3AE4F}"/>
              </a:ext>
            </a:extLst>
          </p:cNvPr>
          <p:cNvCxnSpPr>
            <a:cxnSpLocks/>
          </p:cNvCxnSpPr>
          <p:nvPr/>
        </p:nvCxnSpPr>
        <p:spPr>
          <a:xfrm>
            <a:off x="1024966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843CCCD-093C-C346-8C42-51DAFE5FCFFB}"/>
              </a:ext>
            </a:extLst>
          </p:cNvPr>
          <p:cNvCxnSpPr>
            <a:cxnSpLocks/>
          </p:cNvCxnSpPr>
          <p:nvPr/>
        </p:nvCxnSpPr>
        <p:spPr>
          <a:xfrm>
            <a:off x="706783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A095A73D-8F03-0047-8D17-42779F3AD260}"/>
              </a:ext>
            </a:extLst>
          </p:cNvPr>
          <p:cNvCxnSpPr>
            <a:cxnSpLocks/>
          </p:cNvCxnSpPr>
          <p:nvPr/>
        </p:nvCxnSpPr>
        <p:spPr>
          <a:xfrm>
            <a:off x="388600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DC36E78F-264B-864E-8596-41F942D03825}"/>
              </a:ext>
            </a:extLst>
          </p:cNvPr>
          <p:cNvCxnSpPr>
            <a:cxnSpLocks/>
          </p:cNvCxnSpPr>
          <p:nvPr/>
        </p:nvCxnSpPr>
        <p:spPr>
          <a:xfrm>
            <a:off x="282539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10A65FBC-A1AD-B740-B620-1A7E79553E07}"/>
              </a:ext>
            </a:extLst>
          </p:cNvPr>
          <p:cNvCxnSpPr>
            <a:cxnSpLocks/>
          </p:cNvCxnSpPr>
          <p:nvPr/>
        </p:nvCxnSpPr>
        <p:spPr>
          <a:xfrm>
            <a:off x="1764782" y="4848292"/>
            <a:ext cx="0" cy="155438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8F2CB96E-E6FD-0541-B16F-C3D8DB174F25}"/>
              </a:ext>
            </a:extLst>
          </p:cNvPr>
          <p:cNvSpPr txBox="1"/>
          <p:nvPr/>
        </p:nvSpPr>
        <p:spPr>
          <a:xfrm>
            <a:off x="9085836" y="4985206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236kb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2E8CEB8-F38D-CA4E-AC3E-359CA4E82520}"/>
              </a:ext>
            </a:extLst>
          </p:cNvPr>
          <p:cNvSpPr txBox="1"/>
          <p:nvPr/>
        </p:nvSpPr>
        <p:spPr>
          <a:xfrm>
            <a:off x="6961761" y="4985206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240k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F9F47EA-53F6-F445-8128-BA0CB206D957}"/>
              </a:ext>
            </a:extLst>
          </p:cNvPr>
          <p:cNvSpPr txBox="1"/>
          <p:nvPr/>
        </p:nvSpPr>
        <p:spPr>
          <a:xfrm>
            <a:off x="4822338" y="4985206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244kb</a:t>
            </a:r>
          </a:p>
        </p:txBody>
      </p: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E3727E18-B48D-5F4F-B19F-28413E950069}"/>
              </a:ext>
            </a:extLst>
          </p:cNvPr>
          <p:cNvGrpSpPr/>
          <p:nvPr/>
        </p:nvGrpSpPr>
        <p:grpSpPr>
          <a:xfrm>
            <a:off x="583094" y="913066"/>
            <a:ext cx="10781746" cy="3201204"/>
            <a:chOff x="583094" y="913066"/>
            <a:chExt cx="11193270" cy="3201204"/>
          </a:xfrm>
        </p:grpSpPr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2DDFD1B0-3622-5F46-A810-4B5D5086FB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4114270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FC61484C-D38F-9A40-929D-4E73A43E30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3958662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3AE5DF02-0117-7D43-850C-85CE3B4D60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3812679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AC8BE6F7-569B-9949-B9C9-0275B57763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3508678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E69B0DA6-AA55-7846-B548-546182CA04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3353070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BC7EAD9B-DC68-B941-8B64-6480866CBF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3207087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5CEE2F94-0C14-2D4A-B5CB-9B2C050755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2957634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DBCFEA96-14C6-3846-85D1-E26F09E831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2802026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B34791A6-8CD6-344B-A6CF-DEFC839D3A6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2656043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729D15A9-2877-A742-809C-ADEE08E956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2352042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C0AFF83F-99F9-D946-9F5F-38C3034739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2196434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FAB3D9FC-CD23-FE45-A475-A1F03EBD9AB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2050451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45169839-C07B-0D4A-A92E-CB2A3FFD131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1820249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0BC560C9-90D3-8542-99F4-B2AC92AE716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1664641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D3BA3B38-8452-D549-914F-3169B8E7516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1518658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FF56738B-F97F-7640-A23D-95325E6FDEE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1214657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945DBD34-9E2A-2546-BDF7-C607F1E34D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1059049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80CB722A-A5C3-8C4B-8851-E1C9CA1E449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3094" y="913066"/>
              <a:ext cx="11193270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TextBox 78">
            <a:extLst>
              <a:ext uri="{FF2B5EF4-FFF2-40B4-BE49-F238E27FC236}">
                <a16:creationId xmlns:a16="http://schemas.microsoft.com/office/drawing/2014/main" id="{74FB1BDA-2E14-024F-9FC2-A897DB6246A3}"/>
              </a:ext>
            </a:extLst>
          </p:cNvPr>
          <p:cNvSpPr txBox="1"/>
          <p:nvPr/>
        </p:nvSpPr>
        <p:spPr>
          <a:xfrm>
            <a:off x="646305" y="920178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▸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834C5F6-577A-034E-BB7A-85FF76603CEA}"/>
              </a:ext>
            </a:extLst>
          </p:cNvPr>
          <p:cNvSpPr txBox="1"/>
          <p:nvPr/>
        </p:nvSpPr>
        <p:spPr>
          <a:xfrm>
            <a:off x="595009" y="1516704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▸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FE4CAF30-F1C1-1F4B-B8B3-4ECECBE099E3}"/>
              </a:ext>
            </a:extLst>
          </p:cNvPr>
          <p:cNvSpPr txBox="1"/>
          <p:nvPr/>
        </p:nvSpPr>
        <p:spPr>
          <a:xfrm>
            <a:off x="646305" y="2055791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▸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7431D90-2EDD-304A-8B87-B24610103BD7}"/>
              </a:ext>
            </a:extLst>
          </p:cNvPr>
          <p:cNvSpPr txBox="1"/>
          <p:nvPr/>
        </p:nvSpPr>
        <p:spPr>
          <a:xfrm>
            <a:off x="595009" y="2670246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▸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74C536F-FFDE-824A-B47C-8C9508F1C944}"/>
              </a:ext>
            </a:extLst>
          </p:cNvPr>
          <p:cNvSpPr txBox="1"/>
          <p:nvPr/>
        </p:nvSpPr>
        <p:spPr>
          <a:xfrm>
            <a:off x="646305" y="3219590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▸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46435B0-9A71-1D41-B315-4A726D3D8AE1}"/>
              </a:ext>
            </a:extLst>
          </p:cNvPr>
          <p:cNvSpPr txBox="1"/>
          <p:nvPr/>
        </p:nvSpPr>
        <p:spPr>
          <a:xfrm>
            <a:off x="595009" y="3816116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1▸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5E5ADE8-6A29-F845-B452-F45564AE26A5}"/>
              </a:ext>
            </a:extLst>
          </p:cNvPr>
          <p:cNvSpPr txBox="1"/>
          <p:nvPr/>
        </p:nvSpPr>
        <p:spPr>
          <a:xfrm>
            <a:off x="646305" y="1229834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▸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DE4D511-3210-CB4C-991D-04D6E861B57E}"/>
              </a:ext>
            </a:extLst>
          </p:cNvPr>
          <p:cNvSpPr txBox="1"/>
          <p:nvPr/>
        </p:nvSpPr>
        <p:spPr>
          <a:xfrm>
            <a:off x="646305" y="2376710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▸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4AEEE99-4344-5142-8E21-14B5F7D421D5}"/>
              </a:ext>
            </a:extLst>
          </p:cNvPr>
          <p:cNvSpPr txBox="1"/>
          <p:nvPr/>
        </p:nvSpPr>
        <p:spPr>
          <a:xfrm>
            <a:off x="646305" y="3534909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▸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CC25621-1DF9-D446-A662-E7F92334A2F0}"/>
              </a:ext>
            </a:extLst>
          </p:cNvPr>
          <p:cNvSpPr txBox="1"/>
          <p:nvPr/>
        </p:nvSpPr>
        <p:spPr>
          <a:xfrm>
            <a:off x="393831" y="398704"/>
            <a:ext cx="8563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ighted Log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737267-AA63-FF42-BB80-0DB0AAE8771C}"/>
              </a:ext>
            </a:extLst>
          </p:cNvPr>
          <p:cNvSpPr txBox="1"/>
          <p:nvPr/>
        </p:nvSpPr>
        <p:spPr>
          <a:xfrm rot="16200000">
            <a:off x="-78924" y="1182686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C6A1DF-636A-A04D-A472-896F2961BEFB}"/>
              </a:ext>
            </a:extLst>
          </p:cNvPr>
          <p:cNvSpPr txBox="1"/>
          <p:nvPr/>
        </p:nvSpPr>
        <p:spPr>
          <a:xfrm rot="16200000">
            <a:off x="-136632" y="2301750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1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444496C-C09F-5449-B2CF-18FDC999A7A2}"/>
              </a:ext>
            </a:extLst>
          </p:cNvPr>
          <p:cNvSpPr txBox="1"/>
          <p:nvPr/>
        </p:nvSpPr>
        <p:spPr>
          <a:xfrm rot="16200000">
            <a:off x="-72513" y="347899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C32BF0F-02F4-EE45-8396-87184AF448E6}"/>
              </a:ext>
            </a:extLst>
          </p:cNvPr>
          <p:cNvSpPr txBox="1"/>
          <p:nvPr/>
        </p:nvSpPr>
        <p:spPr>
          <a:xfrm>
            <a:off x="523525" y="4985206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g38 Chr1: 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C70C260-166D-AC4C-878B-98279A2A71BD}"/>
              </a:ext>
            </a:extLst>
          </p:cNvPr>
          <p:cNvSpPr txBox="1"/>
          <p:nvPr/>
        </p:nvSpPr>
        <p:spPr>
          <a:xfrm>
            <a:off x="1863700" y="4338893"/>
            <a:ext cx="769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BT →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E4D713B-8999-5B44-BD4B-CD0369272D9F}"/>
              </a:ext>
            </a:extLst>
          </p:cNvPr>
          <p:cNvSpPr txBox="1"/>
          <p:nvPr/>
        </p:nvSpPr>
        <p:spPr>
          <a:xfrm>
            <a:off x="1863700" y="4575135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on 1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6F18C82-6CC4-0E4D-BA0F-70BB517694F9}"/>
              </a:ext>
            </a:extLst>
          </p:cNvPr>
          <p:cNvSpPr txBox="1"/>
          <p:nvPr/>
        </p:nvSpPr>
        <p:spPr>
          <a:xfrm>
            <a:off x="6630580" y="4566395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on 2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C2E2F7B-ADE7-1947-9051-28F68C40FF17}"/>
              </a:ext>
            </a:extLst>
          </p:cNvPr>
          <p:cNvSpPr txBox="1"/>
          <p:nvPr/>
        </p:nvSpPr>
        <p:spPr>
          <a:xfrm>
            <a:off x="9481229" y="456639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on 3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7CB6C9E-09D5-C346-B483-F71D51E4BFB1}"/>
              </a:ext>
            </a:extLst>
          </p:cNvPr>
          <p:cNvSpPr txBox="1"/>
          <p:nvPr/>
        </p:nvSpPr>
        <p:spPr>
          <a:xfrm>
            <a:off x="9572715" y="1043349"/>
            <a:ext cx="1770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Homozygous reference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9FD6967-5D0F-FF47-937E-7A13150069C5}"/>
              </a:ext>
            </a:extLst>
          </p:cNvPr>
          <p:cNvSpPr txBox="1"/>
          <p:nvPr/>
        </p:nvSpPr>
        <p:spPr>
          <a:xfrm>
            <a:off x="9659277" y="3367584"/>
            <a:ext cx="16578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Homozygous deletion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2B327A7-EEFB-CE4A-85C0-E0E04941182F}"/>
              </a:ext>
            </a:extLst>
          </p:cNvPr>
          <p:cNvSpPr txBox="1"/>
          <p:nvPr/>
        </p:nvSpPr>
        <p:spPr>
          <a:xfrm>
            <a:off x="9633629" y="2237696"/>
            <a:ext cx="1709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Heterozygous deletion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C154F8B-5FF9-3542-A07E-010012545CD8}"/>
              </a:ext>
            </a:extLst>
          </p:cNvPr>
          <p:cNvSpPr txBox="1"/>
          <p:nvPr/>
        </p:nvSpPr>
        <p:spPr>
          <a:xfrm>
            <a:off x="2682915" y="4999889"/>
            <a:ext cx="8563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248k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1511174A-FB3C-D597-9AFD-DFB5484399B2}"/>
              </a:ext>
            </a:extLst>
          </p:cNvPr>
          <p:cNvSpPr/>
          <p:nvPr/>
        </p:nvSpPr>
        <p:spPr>
          <a:xfrm>
            <a:off x="385304" y="5840673"/>
            <a:ext cx="1100183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on targeted array data indicating reduced hybridization for exon 2 probes. Control sample shows Exon 2 probes clustering around Log2 ratio of 0 indicating normal copy number. Case 10 and case 1 show progressively less exon 2 probe binding indicative of heterozygous and homozygous deletion of exon 2, respectively. </a:t>
            </a:r>
          </a:p>
        </p:txBody>
      </p:sp>
    </p:spTree>
    <p:extLst>
      <p:ext uri="{BB962C8B-B14F-4D97-AF65-F5344CB8AC3E}">
        <p14:creationId xmlns:p14="http://schemas.microsoft.com/office/powerpoint/2010/main" val="2123095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B8A847D9-D52D-7C48-B382-59D178CB8F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4351" y="886947"/>
            <a:ext cx="9895840" cy="1404639"/>
          </a:xfrm>
          <a:prstGeom prst="rect">
            <a:avLst/>
          </a:prstGeom>
        </p:spPr>
      </p:pic>
      <p:sp>
        <p:nvSpPr>
          <p:cNvPr id="7" name="Left Bracket 6">
            <a:extLst>
              <a:ext uri="{FF2B5EF4-FFF2-40B4-BE49-F238E27FC236}">
                <a16:creationId xmlns:a16="http://schemas.microsoft.com/office/drawing/2014/main" id="{7B4F4FBB-B8D5-B54E-9ECC-20B8ACB2B7DA}"/>
              </a:ext>
            </a:extLst>
          </p:cNvPr>
          <p:cNvSpPr/>
          <p:nvPr/>
        </p:nvSpPr>
        <p:spPr>
          <a:xfrm rot="16200000">
            <a:off x="3383825" y="-223181"/>
            <a:ext cx="39817" cy="5010678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1" name="Left Bracket 10">
            <a:extLst>
              <a:ext uri="{FF2B5EF4-FFF2-40B4-BE49-F238E27FC236}">
                <a16:creationId xmlns:a16="http://schemas.microsoft.com/office/drawing/2014/main" id="{470A237E-90D8-A641-911B-0F42980559F2}"/>
              </a:ext>
            </a:extLst>
          </p:cNvPr>
          <p:cNvSpPr/>
          <p:nvPr/>
        </p:nvSpPr>
        <p:spPr>
          <a:xfrm rot="16200000">
            <a:off x="7110299" y="-790506"/>
            <a:ext cx="60950" cy="6312457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921F9D6-D43F-F14F-870D-A13514DC024F}"/>
              </a:ext>
            </a:extLst>
          </p:cNvPr>
          <p:cNvSpPr/>
          <p:nvPr/>
        </p:nvSpPr>
        <p:spPr>
          <a:xfrm>
            <a:off x="7513869" y="2439859"/>
            <a:ext cx="278313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hg37] Chr1:100,704,654-100,704,632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hg38] Chr1:100,239,098-100,239,076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C2DA573-5EA1-9449-8C5C-FCA6991033CE}"/>
              </a:ext>
            </a:extLst>
          </p:cNvPr>
          <p:cNvSpPr/>
          <p:nvPr/>
        </p:nvSpPr>
        <p:spPr>
          <a:xfrm>
            <a:off x="898394" y="2439859"/>
            <a:ext cx="278313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hg37] Chr1:100,711,983-100,711,966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hg38] Chr1:100,246,427-100,246,410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16A6227-BEC7-9F42-95FF-257CF40F86FE}"/>
              </a:ext>
            </a:extLst>
          </p:cNvPr>
          <p:cNvSpPr/>
          <p:nvPr/>
        </p:nvSpPr>
        <p:spPr>
          <a:xfrm>
            <a:off x="3605428" y="407177"/>
            <a:ext cx="282641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hg37] Chr1:100,711,983-100,711,951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[hg38] Chr1:100,246,427-100,246,395 </a:t>
            </a:r>
          </a:p>
        </p:txBody>
      </p:sp>
      <p:sp>
        <p:nvSpPr>
          <p:cNvPr id="15" name="Left Bracket 14">
            <a:extLst>
              <a:ext uri="{FF2B5EF4-FFF2-40B4-BE49-F238E27FC236}">
                <a16:creationId xmlns:a16="http://schemas.microsoft.com/office/drawing/2014/main" id="{375F8037-31F9-4F40-9AA7-7E40CC6E9FB2}"/>
              </a:ext>
            </a:extLst>
          </p:cNvPr>
          <p:cNvSpPr/>
          <p:nvPr/>
        </p:nvSpPr>
        <p:spPr>
          <a:xfrm rot="5400000" flipV="1">
            <a:off x="5569830" y="-3716695"/>
            <a:ext cx="55740" cy="939861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60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61CC219-91C0-C44F-B0FF-8B8E99EE7581}"/>
              </a:ext>
            </a:extLst>
          </p:cNvPr>
          <p:cNvSpPr txBox="1"/>
          <p:nvPr/>
        </p:nvSpPr>
        <p:spPr>
          <a:xfrm>
            <a:off x="581393" y="722810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ferenc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F2DFA7A-7368-BE40-874E-6BACE38956B2}"/>
              </a:ext>
            </a:extLst>
          </p:cNvPr>
          <p:cNvSpPr txBox="1"/>
          <p:nvPr/>
        </p:nvSpPr>
        <p:spPr>
          <a:xfrm>
            <a:off x="581393" y="1522749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ase 7</a:t>
            </a:r>
          </a:p>
        </p:txBody>
      </p:sp>
      <p:grpSp>
        <p:nvGrpSpPr>
          <p:cNvPr id="59" name="Group 58">
            <a:extLst>
              <a:ext uri="{FF2B5EF4-FFF2-40B4-BE49-F238E27FC236}">
                <a16:creationId xmlns:a16="http://schemas.microsoft.com/office/drawing/2014/main" id="{4D5FFEEB-AAFE-2640-8C4D-C1573564F8A3}"/>
              </a:ext>
            </a:extLst>
          </p:cNvPr>
          <p:cNvGrpSpPr/>
          <p:nvPr/>
        </p:nvGrpSpPr>
        <p:grpSpPr>
          <a:xfrm>
            <a:off x="1150902" y="3813882"/>
            <a:ext cx="4801365" cy="1227328"/>
            <a:chOff x="11954" y="3136812"/>
            <a:chExt cx="12312480" cy="1935444"/>
          </a:xfrm>
        </p:grpSpPr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A699FD0A-5609-1242-B0FB-8E4CF7BD2381}"/>
                </a:ext>
              </a:extLst>
            </p:cNvPr>
            <p:cNvCxnSpPr>
              <a:cxnSpLocks/>
            </p:cNvCxnSpPr>
            <p:nvPr/>
          </p:nvCxnSpPr>
          <p:spPr>
            <a:xfrm>
              <a:off x="2743200" y="3429000"/>
              <a:ext cx="0" cy="1008529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A3D3000A-6667-154F-AB81-10A344A923DC}"/>
                </a:ext>
              </a:extLst>
            </p:cNvPr>
            <p:cNvCxnSpPr>
              <a:cxnSpLocks/>
            </p:cNvCxnSpPr>
            <p:nvPr/>
          </p:nvCxnSpPr>
          <p:spPr>
            <a:xfrm>
              <a:off x="9565341" y="3429000"/>
              <a:ext cx="0" cy="1008529"/>
            </a:xfrm>
            <a:prstGeom prst="line">
              <a:avLst/>
            </a:prstGeom>
            <a:ln w="38100">
              <a:prstDash val="sysDash"/>
            </a:ln>
          </p:spPr>
          <p:style>
            <a:lnRef idx="1">
              <a:schemeClr val="accent6"/>
            </a:lnRef>
            <a:fillRef idx="0">
              <a:schemeClr val="accent6"/>
            </a:fillRef>
            <a:effectRef idx="0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D8E717AA-DA40-4B49-953A-6437E28BDD2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94330" y="3903063"/>
              <a:ext cx="6941982" cy="0"/>
            </a:xfrm>
            <a:prstGeom prst="line">
              <a:avLst/>
            </a:prstGeom>
            <a:ln w="571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5C54E930-F9DD-C845-A7BE-11194DBB79B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77304" y="3903063"/>
              <a:ext cx="2124877" cy="0"/>
            </a:xfrm>
            <a:prstGeom prst="line">
              <a:avLst/>
            </a:prstGeom>
            <a:ln w="57150"/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D4B0E13A-DD61-B343-88D8-E9925BB060DA}"/>
                </a:ext>
              </a:extLst>
            </p:cNvPr>
            <p:cNvSpPr txBox="1"/>
            <p:nvPr/>
          </p:nvSpPr>
          <p:spPr>
            <a:xfrm>
              <a:off x="4083155" y="3967772"/>
              <a:ext cx="1631131" cy="5824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Exon 2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BT</a:t>
              </a:r>
              <a:endParaRPr kumimoji="0" lang="en-US" sz="9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4EEBC702-6319-AE49-8EC2-2AF1EB5032E1}"/>
                </a:ext>
              </a:extLst>
            </p:cNvPr>
            <p:cNvCxnSpPr>
              <a:cxnSpLocks/>
            </p:cNvCxnSpPr>
            <p:nvPr/>
          </p:nvCxnSpPr>
          <p:spPr>
            <a:xfrm>
              <a:off x="2931981" y="3425301"/>
              <a:ext cx="482438" cy="0"/>
            </a:xfrm>
            <a:prstGeom prst="straightConnector1">
              <a:avLst/>
            </a:prstGeom>
            <a:ln w="38100">
              <a:solidFill>
                <a:srgbClr val="B11FA0"/>
              </a:solidFill>
              <a:headEnd type="triangle" w="med" len="sm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AF573CF2-11D7-AA40-9A0E-A5D2CF18E9C2}"/>
                </a:ext>
              </a:extLst>
            </p:cNvPr>
            <p:cNvCxnSpPr>
              <a:cxnSpLocks/>
            </p:cNvCxnSpPr>
            <p:nvPr/>
          </p:nvCxnSpPr>
          <p:spPr>
            <a:xfrm>
              <a:off x="2560243" y="3136812"/>
              <a:ext cx="7255042" cy="32033"/>
            </a:xfrm>
            <a:prstGeom prst="straightConnector1">
              <a:avLst/>
            </a:prstGeom>
            <a:ln w="38100">
              <a:solidFill>
                <a:srgbClr val="B11FA0"/>
              </a:solidFill>
              <a:headEnd type="triangle" w="med" len="sm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4584CAC-3A2E-1440-A307-90A035F9A58A}"/>
                </a:ext>
              </a:extLst>
            </p:cNvPr>
            <p:cNvSpPr txBox="1"/>
            <p:nvPr/>
          </p:nvSpPr>
          <p:spPr>
            <a:xfrm>
              <a:off x="11954" y="4489835"/>
              <a:ext cx="5488599" cy="5824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tron 2 breaking point: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[hg38] Chr1:100,239,092-100,239,098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2CE43E4-9C75-064B-93E4-CCE9C10356FB}"/>
                </a:ext>
              </a:extLst>
            </p:cNvPr>
            <p:cNvSpPr txBox="1"/>
            <p:nvPr/>
          </p:nvSpPr>
          <p:spPr>
            <a:xfrm>
              <a:off x="6835837" y="4488247"/>
              <a:ext cx="5488597" cy="5824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tron 1 breaking point:</a:t>
              </a: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[hg38] Chr1:100,246,410-100,246,416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FD28A9D-353A-DE4A-93F7-62C9BB5E7645}"/>
                </a:ext>
              </a:extLst>
            </p:cNvPr>
            <p:cNvSpPr txBox="1"/>
            <p:nvPr/>
          </p:nvSpPr>
          <p:spPr>
            <a:xfrm>
              <a:off x="8904521" y="3953781"/>
              <a:ext cx="1476561" cy="364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tron 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E6E7082-8142-1445-9568-2B4D29F7DE8D}"/>
                </a:ext>
              </a:extLst>
            </p:cNvPr>
            <p:cNvSpPr txBox="1"/>
            <p:nvPr/>
          </p:nvSpPr>
          <p:spPr>
            <a:xfrm>
              <a:off x="2029788" y="3939625"/>
              <a:ext cx="1476561" cy="3640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tron 2</a:t>
              </a:r>
            </a:p>
          </p:txBody>
        </p: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688A9D47-9119-354B-A3B6-2BB42B269B34}"/>
                </a:ext>
              </a:extLst>
            </p:cNvPr>
            <p:cNvCxnSpPr>
              <a:cxnSpLocks/>
            </p:cNvCxnSpPr>
            <p:nvPr/>
          </p:nvCxnSpPr>
          <p:spPr>
            <a:xfrm>
              <a:off x="8930201" y="3405560"/>
              <a:ext cx="482438" cy="0"/>
            </a:xfrm>
            <a:prstGeom prst="straightConnector1">
              <a:avLst/>
            </a:prstGeom>
            <a:ln w="38100">
              <a:solidFill>
                <a:srgbClr val="B11FA0"/>
              </a:solidFill>
              <a:headEnd type="triangle" w="med" len="sm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92CD694D-1706-7843-BE16-166443503774}"/>
                </a:ext>
              </a:extLst>
            </p:cNvPr>
            <p:cNvSpPr txBox="1"/>
            <p:nvPr/>
          </p:nvSpPr>
          <p:spPr>
            <a:xfrm>
              <a:off x="8323807" y="3416914"/>
              <a:ext cx="1460888" cy="364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R 1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A128743-86F0-5941-BB98-DAB1FB0BA6D6}"/>
                </a:ext>
              </a:extLst>
            </p:cNvPr>
            <p:cNvSpPr txBox="1"/>
            <p:nvPr/>
          </p:nvSpPr>
          <p:spPr>
            <a:xfrm>
              <a:off x="2809174" y="3439758"/>
              <a:ext cx="1460896" cy="364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R 2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B1C6E1A8-25D9-D849-8FFE-245D7AADE3C9}"/>
                </a:ext>
              </a:extLst>
            </p:cNvPr>
            <p:cNvSpPr txBox="1"/>
            <p:nvPr/>
          </p:nvSpPr>
          <p:spPr>
            <a:xfrm>
              <a:off x="5493148" y="3146898"/>
              <a:ext cx="1389229" cy="364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R 3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CD6C401D-1CF9-D94D-9E33-A15E4A03ABA4}"/>
                </a:ext>
              </a:extLst>
            </p:cNvPr>
            <p:cNvCxnSpPr>
              <a:cxnSpLocks/>
            </p:cNvCxnSpPr>
            <p:nvPr/>
          </p:nvCxnSpPr>
          <p:spPr>
            <a:xfrm>
              <a:off x="4399191" y="3903063"/>
              <a:ext cx="384682" cy="0"/>
            </a:xfrm>
            <a:prstGeom prst="line">
              <a:avLst/>
            </a:prstGeom>
            <a:ln w="1270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>
              <a:extLst>
                <a:ext uri="{FF2B5EF4-FFF2-40B4-BE49-F238E27FC236}">
                  <a16:creationId xmlns:a16="http://schemas.microsoft.com/office/drawing/2014/main" id="{41C29286-56AF-034D-B45D-8EDDE08921D3}"/>
                </a:ext>
              </a:extLst>
            </p:cNvPr>
            <p:cNvCxnSpPr/>
            <p:nvPr/>
          </p:nvCxnSpPr>
          <p:spPr>
            <a:xfrm flipH="1">
              <a:off x="7159083" y="3903063"/>
              <a:ext cx="1771118" cy="0"/>
            </a:xfrm>
            <a:prstGeom prst="straightConnector1">
              <a:avLst/>
            </a:prstGeom>
            <a:ln w="57150">
              <a:solidFill>
                <a:srgbClr val="EE7D3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112ADCD3-310C-B347-AB80-2D4FE59FCFF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86656" y="3903063"/>
              <a:ext cx="983413" cy="0"/>
            </a:xfrm>
            <a:prstGeom prst="straightConnector1">
              <a:avLst/>
            </a:prstGeom>
            <a:ln w="57150">
              <a:solidFill>
                <a:srgbClr val="EE7D3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63" name="Table 63">
            <a:extLst>
              <a:ext uri="{FF2B5EF4-FFF2-40B4-BE49-F238E27FC236}">
                <a16:creationId xmlns:a16="http://schemas.microsoft.com/office/drawing/2014/main" id="{FF04EF17-D7DF-0F4A-B81D-ABAC5AEB6A80}"/>
              </a:ext>
            </a:extLst>
          </p:cNvPr>
          <p:cNvGraphicFramePr>
            <a:graphicFrameLocks noGrp="1"/>
          </p:cNvGraphicFramePr>
          <p:nvPr/>
        </p:nvGraphicFramePr>
        <p:xfrm>
          <a:off x="581393" y="5270276"/>
          <a:ext cx="6073762" cy="118395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94538">
                  <a:extLst>
                    <a:ext uri="{9D8B030D-6E8A-4147-A177-3AD203B41FA5}">
                      <a16:colId xmlns:a16="http://schemas.microsoft.com/office/drawing/2014/main" val="2472982837"/>
                    </a:ext>
                  </a:extLst>
                </a:gridCol>
                <a:gridCol w="2045145">
                  <a:extLst>
                    <a:ext uri="{9D8B030D-6E8A-4147-A177-3AD203B41FA5}">
                      <a16:colId xmlns:a16="http://schemas.microsoft.com/office/drawing/2014/main" val="4136414718"/>
                    </a:ext>
                  </a:extLst>
                </a:gridCol>
                <a:gridCol w="1930400">
                  <a:extLst>
                    <a:ext uri="{9D8B030D-6E8A-4147-A177-3AD203B41FA5}">
                      <a16:colId xmlns:a16="http://schemas.microsoft.com/office/drawing/2014/main" val="2986023664"/>
                    </a:ext>
                  </a:extLst>
                </a:gridCol>
                <a:gridCol w="1503679">
                  <a:extLst>
                    <a:ext uri="{9D8B030D-6E8A-4147-A177-3AD203B41FA5}">
                      <a16:colId xmlns:a16="http://schemas.microsoft.com/office/drawing/2014/main" val="2415832851"/>
                    </a:ext>
                  </a:extLst>
                </a:gridCol>
              </a:tblGrid>
              <a:tr h="218846">
                <a:tc>
                  <a:txBody>
                    <a:bodyPr/>
                    <a:lstStyle/>
                    <a:p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lic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0189579"/>
                  </a:ext>
                </a:extLst>
              </a:tr>
              <a:tr h="28306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Courier" pitchFamily="2" charset="0"/>
                          <a:cs typeface="Arial" panose="020B0604020202020204" pitchFamily="34" charset="0"/>
                        </a:rPr>
                        <a:t>TGTCTGACTTTAGGAGTGCT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Courier" pitchFamily="2" charset="0"/>
                          <a:cs typeface="Arial" panose="020B0604020202020204" pitchFamily="34" charset="0"/>
                        </a:rPr>
                        <a:t>ACTGTTCACCAAAGTAGCGT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bp or  no produ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75720"/>
                  </a:ext>
                </a:extLst>
              </a:tr>
              <a:tr h="28306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Courier" pitchFamily="2" charset="0"/>
                          <a:cs typeface="Arial" panose="020B0604020202020204" pitchFamily="34" charset="0"/>
                        </a:rPr>
                        <a:t>CTGGATACACCAGTTCCAGG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Courier" pitchFamily="2" charset="0"/>
                          <a:cs typeface="Arial" panose="020B0604020202020204" pitchFamily="34" charset="0"/>
                        </a:rPr>
                        <a:t>TTCCCAGATGGTGAAACTTG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bp or no produc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9439809"/>
                  </a:ext>
                </a:extLst>
              </a:tr>
              <a:tr h="389217">
                <a:tc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Courier" pitchFamily="2" charset="0"/>
                          <a:cs typeface="Arial" panose="020B0604020202020204" pitchFamily="34" charset="0"/>
                        </a:rPr>
                        <a:t>TCTTCCTGTAGTAAAGTGTAAGC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Courier" pitchFamily="2" charset="0"/>
                          <a:cs typeface="Arial" panose="020B0604020202020204" pitchFamily="34" charset="0"/>
                        </a:rPr>
                        <a:t>CACCCAAGTATAAGGATCTTTGTT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31bp or </a:t>
                      </a:r>
                    </a:p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 bp if dele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68140354"/>
                  </a:ext>
                </a:extLst>
              </a:tr>
            </a:tbl>
          </a:graphicData>
        </a:graphic>
      </p:graphicFrame>
      <p:sp>
        <p:nvSpPr>
          <p:cNvPr id="68" name="TextBox 67">
            <a:extLst>
              <a:ext uri="{FF2B5EF4-FFF2-40B4-BE49-F238E27FC236}">
                <a16:creationId xmlns:a16="http://schemas.microsoft.com/office/drawing/2014/main" id="{7F24FEA5-E8BD-284B-AE2B-C9D20D735BC3}"/>
              </a:ext>
            </a:extLst>
          </p:cNvPr>
          <p:cNvSpPr txBox="1"/>
          <p:nvPr/>
        </p:nvSpPr>
        <p:spPr>
          <a:xfrm>
            <a:off x="101945" y="378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664215B-C17E-F343-835E-94BE863BF841}"/>
              </a:ext>
            </a:extLst>
          </p:cNvPr>
          <p:cNvSpPr txBox="1"/>
          <p:nvPr/>
        </p:nvSpPr>
        <p:spPr>
          <a:xfrm>
            <a:off x="103820" y="346581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0FA5C79-50BF-AEAD-BCEF-1242CA6FAD22}"/>
              </a:ext>
            </a:extLst>
          </p:cNvPr>
          <p:cNvSpPr/>
          <p:nvPr/>
        </p:nvSpPr>
        <p:spPr>
          <a:xfrm>
            <a:off x="6750835" y="3780546"/>
            <a:ext cx="5358929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anger sequencing confirmation of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delEx2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ariant detected by next generation sequencing. </a:t>
            </a:r>
          </a:p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AutoNum type="alphaUcParenR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anger sequencing confirms the deletion of exon 2 in Case 7. A 7bp area of homology with intron 1 and intron 2 is detected on either side of the roughly 7.4kb deletion.</a:t>
            </a:r>
          </a:p>
          <a:p>
            <a:pPr marL="228600" indent="-228600">
              <a:buAutoNum type="alphaUcParenR"/>
            </a:pP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>
              <a:buAutoNum type="alphaUcParenR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hematic of primer design utilized for confirmation of exon 2 deletion with primer sequences. For sequencing, PCR 3 has M13F and M13R tails; M13 sequences not shown. </a:t>
            </a:r>
          </a:p>
        </p:txBody>
      </p:sp>
    </p:spTree>
    <p:extLst>
      <p:ext uri="{BB962C8B-B14F-4D97-AF65-F5344CB8AC3E}">
        <p14:creationId xmlns:p14="http://schemas.microsoft.com/office/powerpoint/2010/main" val="42013405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E1D66B-BB40-8248-9C66-5E9AA923E14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718" b="4493"/>
          <a:stretch/>
        </p:blipFill>
        <p:spPr>
          <a:xfrm>
            <a:off x="2041146" y="1399006"/>
            <a:ext cx="1934734" cy="15291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2CCFB3D-8D34-8A42-836F-0B5865E3795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5616" b="6929"/>
          <a:stretch/>
        </p:blipFill>
        <p:spPr>
          <a:xfrm>
            <a:off x="2042762" y="3039464"/>
            <a:ext cx="1925664" cy="150036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23957EA-FB01-0A46-B21A-5CC2AF89E68F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4183326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ECA1F7C-2D1F-3048-9C76-8F2FD261E66C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4014598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DD73E3B-F51A-4545-8492-515DCDE99073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3837705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0AC6B31-8702-CF47-813C-CD637753FF2C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3491763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37E9893-88A0-D74A-84FA-CB9C5F916F56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3314870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Oval 33">
            <a:extLst>
              <a:ext uri="{FF2B5EF4-FFF2-40B4-BE49-F238E27FC236}">
                <a16:creationId xmlns:a16="http://schemas.microsoft.com/office/drawing/2014/main" id="{F2292CF8-1365-654C-AC66-B5A38FD8A4AC}"/>
              </a:ext>
            </a:extLst>
          </p:cNvPr>
          <p:cNvSpPr/>
          <p:nvPr/>
        </p:nvSpPr>
        <p:spPr>
          <a:xfrm>
            <a:off x="3596893" y="960919"/>
            <a:ext cx="417786" cy="402021"/>
          </a:xfrm>
          <a:prstGeom prst="ellips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236B0031-E5E1-2B44-B033-CA2E43733A9B}"/>
              </a:ext>
            </a:extLst>
          </p:cNvPr>
          <p:cNvSpPr/>
          <p:nvPr/>
        </p:nvSpPr>
        <p:spPr>
          <a:xfrm>
            <a:off x="4514849" y="960920"/>
            <a:ext cx="430211" cy="402021"/>
          </a:xfrm>
          <a:prstGeom prst="rect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861A32F-B45F-AB49-9517-42362B719ED0}"/>
              </a:ext>
            </a:extLst>
          </p:cNvPr>
          <p:cNvSpPr/>
          <p:nvPr/>
        </p:nvSpPr>
        <p:spPr>
          <a:xfrm>
            <a:off x="4059713" y="3017837"/>
            <a:ext cx="430211" cy="402021"/>
          </a:xfrm>
          <a:prstGeom prst="rect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3897F501-0061-D84B-B80E-574A0DDFD5B6}"/>
              </a:ext>
            </a:extLst>
          </p:cNvPr>
          <p:cNvCxnSpPr>
            <a:stCxn id="34" idx="6"/>
            <a:endCxn id="36" idx="1"/>
          </p:cNvCxnSpPr>
          <p:nvPr/>
        </p:nvCxnSpPr>
        <p:spPr>
          <a:xfrm>
            <a:off x="4014679" y="1161930"/>
            <a:ext cx="500170" cy="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3E34B689-A632-4D47-9B56-A8C85EF38623}"/>
              </a:ext>
            </a:extLst>
          </p:cNvPr>
          <p:cNvCxnSpPr>
            <a:cxnSpLocks/>
            <a:endCxn id="39" idx="0"/>
          </p:cNvCxnSpPr>
          <p:nvPr/>
        </p:nvCxnSpPr>
        <p:spPr>
          <a:xfrm>
            <a:off x="4274819" y="1168285"/>
            <a:ext cx="0" cy="184955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Pie 46">
            <a:extLst>
              <a:ext uri="{FF2B5EF4-FFF2-40B4-BE49-F238E27FC236}">
                <a16:creationId xmlns:a16="http://schemas.microsoft.com/office/drawing/2014/main" id="{EC783049-F419-C54D-A25E-516BFCC6EBE3}"/>
              </a:ext>
            </a:extLst>
          </p:cNvPr>
          <p:cNvSpPr/>
          <p:nvPr/>
        </p:nvSpPr>
        <p:spPr>
          <a:xfrm>
            <a:off x="3600319" y="964859"/>
            <a:ext cx="417786" cy="402022"/>
          </a:xfrm>
          <a:prstGeom prst="pie">
            <a:avLst>
              <a:gd name="adj1" fmla="val 5400004"/>
              <a:gd name="adj2" fmla="val 16200000"/>
            </a:avLst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6B92BA4-D04C-5743-8B82-3A5CAC4C989A}"/>
              </a:ext>
            </a:extLst>
          </p:cNvPr>
          <p:cNvSpPr/>
          <p:nvPr/>
        </p:nvSpPr>
        <p:spPr>
          <a:xfrm>
            <a:off x="4729954" y="960919"/>
            <a:ext cx="210560" cy="402020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F01E5A1-8492-1C4B-A486-948D45CA6058}"/>
              </a:ext>
            </a:extLst>
          </p:cNvPr>
          <p:cNvSpPr/>
          <p:nvPr/>
        </p:nvSpPr>
        <p:spPr>
          <a:xfrm>
            <a:off x="4274817" y="3024191"/>
            <a:ext cx="210560" cy="395667"/>
          </a:xfrm>
          <a:prstGeom prst="rect">
            <a:avLst/>
          </a:prstGeom>
          <a:solidFill>
            <a:srgbClr val="FF0000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01" name="Group 100">
            <a:extLst>
              <a:ext uri="{FF2B5EF4-FFF2-40B4-BE49-F238E27FC236}">
                <a16:creationId xmlns:a16="http://schemas.microsoft.com/office/drawing/2014/main" id="{BCACC5DF-6138-1441-9D2F-B53823631787}"/>
              </a:ext>
            </a:extLst>
          </p:cNvPr>
          <p:cNvGrpSpPr/>
          <p:nvPr/>
        </p:nvGrpSpPr>
        <p:grpSpPr>
          <a:xfrm>
            <a:off x="4542600" y="2543921"/>
            <a:ext cx="4730915" cy="595534"/>
            <a:chOff x="4514848" y="1386161"/>
            <a:chExt cx="4730915" cy="59553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EAAF418-CA67-0D4D-956E-2567B04458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4914" t="83229" b="3428"/>
            <a:stretch/>
          </p:blipFill>
          <p:spPr>
            <a:xfrm flipH="1" flipV="1">
              <a:off x="4514848" y="1443127"/>
              <a:ext cx="4730913" cy="39856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F7A512E7-0FF6-574E-83AA-DC3922B0A9F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14849" y="1981695"/>
              <a:ext cx="4730914" cy="0"/>
            </a:xfrm>
            <a:prstGeom prst="line">
              <a:avLst/>
            </a:prstGeom>
            <a:ln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815C82F-FC33-FE41-8C44-09E13D3B3384}"/>
                </a:ext>
              </a:extLst>
            </p:cNvPr>
            <p:cNvSpPr txBox="1"/>
            <p:nvPr/>
          </p:nvSpPr>
          <p:spPr>
            <a:xfrm>
              <a:off x="4745899" y="1602804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xon 1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3867CB2-E14B-A64A-88D8-70A9C27D78D9}"/>
                </a:ext>
              </a:extLst>
            </p:cNvPr>
            <p:cNvSpPr txBox="1"/>
            <p:nvPr/>
          </p:nvSpPr>
          <p:spPr>
            <a:xfrm>
              <a:off x="6970118" y="1602804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xon 2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9A0ACC3-DD88-3548-893D-4309947C18D7}"/>
                </a:ext>
              </a:extLst>
            </p:cNvPr>
            <p:cNvSpPr txBox="1"/>
            <p:nvPr/>
          </p:nvSpPr>
          <p:spPr>
            <a:xfrm>
              <a:off x="8293946" y="1602804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xon 3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15D928F-5F98-7E45-922E-58DD81FEB74E}"/>
                </a:ext>
              </a:extLst>
            </p:cNvPr>
            <p:cNvSpPr txBox="1"/>
            <p:nvPr/>
          </p:nvSpPr>
          <p:spPr>
            <a:xfrm>
              <a:off x="4784061" y="1386161"/>
              <a:ext cx="769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BT →</a:t>
              </a:r>
            </a:p>
          </p:txBody>
        </p: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850731DB-A1F6-D943-96B7-D28A7356054B}"/>
              </a:ext>
            </a:extLst>
          </p:cNvPr>
          <p:cNvSpPr txBox="1"/>
          <p:nvPr/>
        </p:nvSpPr>
        <p:spPr>
          <a:xfrm rot="16200000">
            <a:off x="1371307" y="1719897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other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5054764-D9C7-AB4D-BC6B-32CC509780EE}"/>
              </a:ext>
            </a:extLst>
          </p:cNvPr>
          <p:cNvSpPr txBox="1"/>
          <p:nvPr/>
        </p:nvSpPr>
        <p:spPr>
          <a:xfrm rot="5400000">
            <a:off x="8938972" y="3481966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10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B99D1FEE-BF3F-1F49-A45D-A6CF1AA1E2E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14" t="3661" b="56003"/>
          <a:stretch/>
        </p:blipFill>
        <p:spPr>
          <a:xfrm flipH="1">
            <a:off x="4542601" y="3054275"/>
            <a:ext cx="4730913" cy="12148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9FAD8E8D-4E0D-BB4B-BACD-8DCF913336EF}"/>
              </a:ext>
            </a:extLst>
          </p:cNvPr>
          <p:cNvSpPr txBox="1"/>
          <p:nvPr/>
        </p:nvSpPr>
        <p:spPr>
          <a:xfrm>
            <a:off x="8947904" y="300822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59A0DFA-FC1E-ED4B-A605-D0C91E2C0FA1}"/>
              </a:ext>
            </a:extLst>
          </p:cNvPr>
          <p:cNvSpPr txBox="1"/>
          <p:nvPr/>
        </p:nvSpPr>
        <p:spPr>
          <a:xfrm>
            <a:off x="8948634" y="317760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BAC49AA-C7BF-BF49-9B11-C6FD7E5586C5}"/>
              </a:ext>
            </a:extLst>
          </p:cNvPr>
          <p:cNvSpPr txBox="1"/>
          <p:nvPr/>
        </p:nvSpPr>
        <p:spPr>
          <a:xfrm>
            <a:off x="8946321" y="334923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8895EA3-1CEF-4B44-8D6F-044AFA0F3F91}"/>
              </a:ext>
            </a:extLst>
          </p:cNvPr>
          <p:cNvSpPr txBox="1"/>
          <p:nvPr/>
        </p:nvSpPr>
        <p:spPr>
          <a:xfrm>
            <a:off x="9015584" y="354214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3C74AA2-4667-144C-A5E3-036D1C941558}"/>
              </a:ext>
            </a:extLst>
          </p:cNvPr>
          <p:cNvSpPr txBox="1"/>
          <p:nvPr/>
        </p:nvSpPr>
        <p:spPr>
          <a:xfrm>
            <a:off x="8895025" y="4060516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.5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E3980E4-E71B-0748-813E-59D1E9A07E60}"/>
              </a:ext>
            </a:extLst>
          </p:cNvPr>
          <p:cNvSpPr txBox="1"/>
          <p:nvPr/>
        </p:nvSpPr>
        <p:spPr>
          <a:xfrm>
            <a:off x="8894295" y="3891135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.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7EE5B0AC-9904-0549-8EB7-C84264DC5A3D}"/>
              </a:ext>
            </a:extLst>
          </p:cNvPr>
          <p:cNvSpPr txBox="1"/>
          <p:nvPr/>
        </p:nvSpPr>
        <p:spPr>
          <a:xfrm>
            <a:off x="8896608" y="371951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C4E9AAAD-94B9-8649-9910-E462F209A12A}"/>
              </a:ext>
            </a:extLst>
          </p:cNvPr>
          <p:cNvCxnSpPr>
            <a:cxnSpLocks/>
          </p:cNvCxnSpPr>
          <p:nvPr/>
        </p:nvCxnSpPr>
        <p:spPr>
          <a:xfrm flipH="1" flipV="1">
            <a:off x="4542603" y="2491949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725D820-C443-BC47-B09C-A388502284F2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2323221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76489A0-551A-BC46-9A44-797521489615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2146328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0A5C5C85-464F-8145-B0FD-566256FB525B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1800386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DCBBAFFB-E203-8B4C-A1FB-364E1DF37350}"/>
              </a:ext>
            </a:extLst>
          </p:cNvPr>
          <p:cNvCxnSpPr>
            <a:cxnSpLocks/>
          </p:cNvCxnSpPr>
          <p:nvPr/>
        </p:nvCxnSpPr>
        <p:spPr>
          <a:xfrm flipH="1" flipV="1">
            <a:off x="4545329" y="1623493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33D6A417-1133-EE46-A104-3762A797168E}"/>
              </a:ext>
            </a:extLst>
          </p:cNvPr>
          <p:cNvSpPr txBox="1"/>
          <p:nvPr/>
        </p:nvSpPr>
        <p:spPr>
          <a:xfrm rot="5400000">
            <a:off x="9035151" y="1747195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ather</a:t>
            </a:r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84A7923E-485E-4C4A-A0CF-7719E203C20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14" t="44268" b="17422"/>
          <a:stretch/>
        </p:blipFill>
        <p:spPr>
          <a:xfrm flipH="1">
            <a:off x="4542602" y="1384786"/>
            <a:ext cx="4730913" cy="11443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2E9D41CC-374A-AF41-8575-ED29CFA13804}"/>
              </a:ext>
            </a:extLst>
          </p:cNvPr>
          <p:cNvSpPr txBox="1"/>
          <p:nvPr/>
        </p:nvSpPr>
        <p:spPr>
          <a:xfrm>
            <a:off x="8932562" y="1320173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84CA1A0E-4F05-EA49-B561-7E397755476F}"/>
              </a:ext>
            </a:extLst>
          </p:cNvPr>
          <p:cNvSpPr txBox="1"/>
          <p:nvPr/>
        </p:nvSpPr>
        <p:spPr>
          <a:xfrm>
            <a:off x="8933292" y="148955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9C2864F-6795-794E-9E0D-7DE5AE188305}"/>
              </a:ext>
            </a:extLst>
          </p:cNvPr>
          <p:cNvSpPr txBox="1"/>
          <p:nvPr/>
        </p:nvSpPr>
        <p:spPr>
          <a:xfrm>
            <a:off x="8930979" y="166117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9F44281-63B1-5D4F-AF06-94EDD19D6B68}"/>
              </a:ext>
            </a:extLst>
          </p:cNvPr>
          <p:cNvSpPr txBox="1"/>
          <p:nvPr/>
        </p:nvSpPr>
        <p:spPr>
          <a:xfrm>
            <a:off x="8986787" y="186987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83C07C73-8EFE-AC49-9AFA-074856D81845}"/>
              </a:ext>
            </a:extLst>
          </p:cNvPr>
          <p:cNvCxnSpPr>
            <a:cxnSpLocks/>
          </p:cNvCxnSpPr>
          <p:nvPr/>
        </p:nvCxnSpPr>
        <p:spPr>
          <a:xfrm flipH="1" flipV="1">
            <a:off x="4542600" y="1443283"/>
            <a:ext cx="4730914" cy="0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18CD4017-19DF-C240-8D57-8715ABF1C730}"/>
              </a:ext>
            </a:extLst>
          </p:cNvPr>
          <p:cNvSpPr txBox="1"/>
          <p:nvPr/>
        </p:nvSpPr>
        <p:spPr>
          <a:xfrm>
            <a:off x="8879321" y="2353496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.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CDF2770-FAC0-F94B-B08B-78F08672050A}"/>
              </a:ext>
            </a:extLst>
          </p:cNvPr>
          <p:cNvSpPr txBox="1"/>
          <p:nvPr/>
        </p:nvSpPr>
        <p:spPr>
          <a:xfrm>
            <a:off x="8878591" y="2184115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.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D9BDE77-8A32-DD4B-95E7-30F8E6B15E63}"/>
              </a:ext>
            </a:extLst>
          </p:cNvPr>
          <p:cNvSpPr txBox="1"/>
          <p:nvPr/>
        </p:nvSpPr>
        <p:spPr>
          <a:xfrm>
            <a:off x="8880904" y="201249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0.5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9A50B84-C21B-A74C-B410-9AFE085C1D77}"/>
              </a:ext>
            </a:extLst>
          </p:cNvPr>
          <p:cNvSpPr txBox="1"/>
          <p:nvPr/>
        </p:nvSpPr>
        <p:spPr>
          <a:xfrm rot="16200000">
            <a:off x="1300774" y="3481966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se 1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56922A49-D15D-2D4E-8C9D-F82508DF1417}"/>
              </a:ext>
            </a:extLst>
          </p:cNvPr>
          <p:cNvSpPr txBox="1"/>
          <p:nvPr/>
        </p:nvSpPr>
        <p:spPr>
          <a:xfrm>
            <a:off x="8908984" y="4282763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0036953-1C91-53AB-AA89-AB6A6C2A90DE}"/>
              </a:ext>
            </a:extLst>
          </p:cNvPr>
          <p:cNvSpPr/>
          <p:nvPr/>
        </p:nvSpPr>
        <p:spPr>
          <a:xfrm>
            <a:off x="2064385" y="4813784"/>
            <a:ext cx="755071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rental testing to determine phase indicates c.916T&gt;C i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tran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with deletion of exon 2 in Case 10. Sanger sequencing of Case 10 and his mother and exon targeted array for Case 10 and his father are shown indicating inheritance of each variant from a separate parent. For Sanger sequencing, the following primers were used:</a:t>
            </a:r>
          </a:p>
          <a:p>
            <a:pPr fontAlgn="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rward = </a:t>
            </a:r>
            <a:r>
              <a:rPr lang="en-US" sz="1400" dirty="0">
                <a:latin typeface="Courier" pitchFamily="2" charset="0"/>
                <a:cs typeface="Arial" panose="020B0604020202020204" pitchFamily="34" charset="0"/>
              </a:rPr>
              <a:t>CATATTGCATGTTGGCAAAGCAA</a:t>
            </a:r>
          </a:p>
          <a:p>
            <a:pPr fontAlgn="t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verse = </a:t>
            </a:r>
            <a:r>
              <a:rPr lang="en-US" sz="1400" dirty="0">
                <a:latin typeface="Courier" pitchFamily="2" charset="0"/>
                <a:cs typeface="Arial" panose="020B0604020202020204" pitchFamily="34" charset="0"/>
              </a:rPr>
              <a:t>CAGCCCTGAAGATACCTCATTTTGG</a:t>
            </a:r>
          </a:p>
        </p:txBody>
      </p:sp>
    </p:spTree>
    <p:extLst>
      <p:ext uri="{BB962C8B-B14F-4D97-AF65-F5344CB8AC3E}">
        <p14:creationId xmlns:p14="http://schemas.microsoft.com/office/powerpoint/2010/main" val="15657497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C5CD178B-8A54-76B0-28B0-C1FD72C9BDF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274" r="1815"/>
          <a:stretch/>
        </p:blipFill>
        <p:spPr>
          <a:xfrm>
            <a:off x="1624657" y="2211242"/>
            <a:ext cx="10440281" cy="323052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006824D-1FC9-9841-8677-6AAEA4F5092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9" t="3348" r="299" b="81807"/>
          <a:stretch/>
        </p:blipFill>
        <p:spPr>
          <a:xfrm>
            <a:off x="1690255" y="1681539"/>
            <a:ext cx="10464776" cy="515002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66E51179-C2C8-9C4D-B21B-2D21E06D31A5}"/>
              </a:ext>
            </a:extLst>
          </p:cNvPr>
          <p:cNvSpPr txBox="1"/>
          <p:nvPr/>
        </p:nvSpPr>
        <p:spPr>
          <a:xfrm>
            <a:off x="418956" y="215034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Case 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76CBC609-0EC2-DC48-A620-9C9FB490A3A8}"/>
              </a:ext>
            </a:extLst>
          </p:cNvPr>
          <p:cNvSpPr txBox="1"/>
          <p:nvPr/>
        </p:nvSpPr>
        <p:spPr>
          <a:xfrm>
            <a:off x="1095633" y="215034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Case 8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7E34771-EF5C-2746-BD0F-6C95195E98BA}"/>
              </a:ext>
            </a:extLst>
          </p:cNvPr>
          <p:cNvSpPr txBox="1"/>
          <p:nvPr/>
        </p:nvSpPr>
        <p:spPr>
          <a:xfrm>
            <a:off x="589286" y="1041694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Case 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5080998-FE55-AA48-8873-56FF10A14B14}"/>
              </a:ext>
            </a:extLst>
          </p:cNvPr>
          <p:cNvSpPr txBox="1"/>
          <p:nvPr/>
        </p:nvSpPr>
        <p:spPr>
          <a:xfrm rot="16200000">
            <a:off x="1265324" y="1433365"/>
            <a:ext cx="4988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</a:rPr>
              <a:t>AOH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AC667B9-5EA7-9740-AE07-854C908D642A}"/>
              </a:ext>
            </a:extLst>
          </p:cNvPr>
          <p:cNvSpPr txBox="1"/>
          <p:nvPr/>
        </p:nvSpPr>
        <p:spPr>
          <a:xfrm rot="16200000">
            <a:off x="1284561" y="751208"/>
            <a:ext cx="4603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</a:rPr>
              <a:t>BAF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A0D70E1-7951-5D4D-AB55-8F14F36CF5AA}"/>
              </a:ext>
            </a:extLst>
          </p:cNvPr>
          <p:cNvSpPr txBox="1"/>
          <p:nvPr/>
        </p:nvSpPr>
        <p:spPr>
          <a:xfrm>
            <a:off x="148066" y="3092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507306E-C6B8-A945-B128-744CA8E35400}"/>
              </a:ext>
            </a:extLst>
          </p:cNvPr>
          <p:cNvSpPr txBox="1"/>
          <p:nvPr/>
        </p:nvSpPr>
        <p:spPr>
          <a:xfrm>
            <a:off x="148066" y="198742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D6CFCBD-E4E9-F745-A662-20A58FC70BB4}"/>
              </a:ext>
            </a:extLst>
          </p:cNvPr>
          <p:cNvSpPr txBox="1"/>
          <p:nvPr/>
        </p:nvSpPr>
        <p:spPr>
          <a:xfrm rot="16200000">
            <a:off x="-124454" y="2651175"/>
            <a:ext cx="976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cordan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81A26A7-4E7A-814B-A464-B14D291C1F65}"/>
              </a:ext>
            </a:extLst>
          </p:cNvPr>
          <p:cNvSpPr txBox="1"/>
          <p:nvPr/>
        </p:nvSpPr>
        <p:spPr>
          <a:xfrm rot="16200000">
            <a:off x="-103803" y="3529336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cordan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657B580-D384-034E-8748-9CB41EED4C0F}"/>
              </a:ext>
            </a:extLst>
          </p:cNvPr>
          <p:cNvSpPr txBox="1"/>
          <p:nvPr/>
        </p:nvSpPr>
        <p:spPr>
          <a:xfrm>
            <a:off x="5536808" y="-60123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2AFB593-A41D-CA48-A8C6-EFC7BA8ABAAE}"/>
              </a:ext>
            </a:extLst>
          </p:cNvPr>
          <p:cNvSpPr txBox="1"/>
          <p:nvPr/>
        </p:nvSpPr>
        <p:spPr>
          <a:xfrm>
            <a:off x="437789" y="2420262"/>
            <a:ext cx="1343638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f =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f</a:t>
            </a:r>
          </a:p>
          <a:p>
            <a:pPr algn="ctr"/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t = het</a:t>
            </a:r>
          </a:p>
          <a:p>
            <a:pPr algn="ctr"/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=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7196EC-D0AD-FB46-8537-C6E1F6955BC6}"/>
              </a:ext>
            </a:extLst>
          </p:cNvPr>
          <p:cNvSpPr txBox="1"/>
          <p:nvPr/>
        </p:nvSpPr>
        <p:spPr>
          <a:xfrm>
            <a:off x="554231" y="3188621"/>
            <a:ext cx="579005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f</a:t>
            </a:r>
          </a:p>
          <a:p>
            <a:pPr algn="r"/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t</a:t>
            </a:r>
          </a:p>
          <a:p>
            <a:pPr algn="r"/>
            <a:r>
              <a:rPr 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algn="r"/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t </a:t>
            </a:r>
          </a:p>
          <a:p>
            <a:pPr algn="r"/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algn="r"/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f </a:t>
            </a:r>
          </a:p>
          <a:p>
            <a:pPr algn="r"/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endParaRPr 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76AE119-4905-0948-9E37-33F17537D06E}"/>
                  </a:ext>
                </a:extLst>
              </p:cNvPr>
              <p:cNvSpPr txBox="1"/>
              <p:nvPr/>
            </p:nvSpPr>
            <p:spPr>
              <a:xfrm>
                <a:off x="962586" y="3194369"/>
                <a:ext cx="290464" cy="9848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800" i="1" smtClean="0">
                          <a:solidFill>
                            <a:srgbClr val="FF0000"/>
                          </a:solidFill>
                          <a:latin typeface="Cambria Math" panose="02040503050406030204" pitchFamily="18" charset="0"/>
                        </a:rPr>
                        <m:t>≠</m:t>
                      </m:r>
                    </m:oMath>
                  </m:oMathPara>
                </a14:m>
                <a:endPara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800" i="1">
                          <a:solidFill>
                            <a:srgbClr val="FF0000"/>
                          </a:solidFill>
                          <a:latin typeface="Cambria Math" panose="02040503050406030204" pitchFamily="18" charset="0"/>
                        </a:rPr>
                        <m:t>≠</m:t>
                      </m:r>
                    </m:oMath>
                  </m:oMathPara>
                </a14:m>
                <a:endPara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 </a:t>
                </a:r>
              </a:p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800" i="1">
                          <a:solidFill>
                            <a:srgbClr val="FF0000"/>
                          </a:solidFill>
                          <a:latin typeface="Cambria Math" panose="02040503050406030204" pitchFamily="18" charset="0"/>
                        </a:rPr>
                        <m:t>≠</m:t>
                      </m:r>
                    </m:oMath>
                  </m:oMathPara>
                </a14:m>
                <a:endPara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800" i="1">
                          <a:solidFill>
                            <a:srgbClr val="FF0000"/>
                          </a:solidFill>
                          <a:latin typeface="Cambria Math" panose="02040503050406030204" pitchFamily="18" charset="0"/>
                        </a:rPr>
                        <m:t>≠</m:t>
                      </m:r>
                    </m:oMath>
                  </m:oMathPara>
                </a14:m>
                <a:endPara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 </a:t>
                </a:r>
              </a:p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800" i="1">
                          <a:solidFill>
                            <a:srgbClr val="FF0000"/>
                          </a:solidFill>
                          <a:latin typeface="Cambria Math" panose="02040503050406030204" pitchFamily="18" charset="0"/>
                        </a:rPr>
                        <m:t>≠</m:t>
                      </m:r>
                    </m:oMath>
                  </m:oMathPara>
                </a14:m>
                <a:endPara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800" i="1">
                          <a:solidFill>
                            <a:srgbClr val="FF0000"/>
                          </a:solidFill>
                          <a:latin typeface="Cambria Math" panose="02040503050406030204" pitchFamily="18" charset="0"/>
                        </a:rPr>
                        <m:t>≠</m:t>
                      </m:r>
                    </m:oMath>
                  </m:oMathPara>
                </a14:m>
                <a:endPara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76AE119-4905-0948-9E37-33F17537D06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962586" y="3194369"/>
                <a:ext cx="290464" cy="984885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4" name="TextBox 13">
            <a:extLst>
              <a:ext uri="{FF2B5EF4-FFF2-40B4-BE49-F238E27FC236}">
                <a16:creationId xmlns:a16="http://schemas.microsoft.com/office/drawing/2014/main" id="{B9B2E1D3-4CB1-924B-A7D0-8121559189BF}"/>
              </a:ext>
            </a:extLst>
          </p:cNvPr>
          <p:cNvSpPr txBox="1"/>
          <p:nvPr/>
        </p:nvSpPr>
        <p:spPr>
          <a:xfrm>
            <a:off x="1095406" y="3184581"/>
            <a:ext cx="550151" cy="9848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t</a:t>
            </a:r>
          </a:p>
          <a:p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f</a:t>
            </a:r>
          </a:p>
          <a:p>
            <a:r>
              <a:rPr 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endParaRPr 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t</a:t>
            </a:r>
          </a:p>
          <a:p>
            <a:r>
              <a:rPr lang="en-US" sz="5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r</a:t>
            </a:r>
            <a:endParaRPr lang="en-US" sz="8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mz</a:t>
            </a:r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f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611801C-9B9F-F288-D094-DB0092B35399}"/>
              </a:ext>
            </a:extLst>
          </p:cNvPr>
          <p:cNvSpPr/>
          <p:nvPr/>
        </p:nvSpPr>
        <p:spPr>
          <a:xfrm>
            <a:off x="148066" y="5047645"/>
            <a:ext cx="11940279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: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Chromosomal microarray analysis of Case 5 indicates a region of homozygosity surrounding the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locus. Depicted is a B allele frequency plot of SNP microarray data. There is a ~15 Mb area of homozygosity (AOH) surrounding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uggestive of a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iplotyp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lock with identity by descent between both copies of this area of chromosome 1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) A genotype concordance plot from residual exome data from Case 7 and Case 8, who are compound heterozygous for delEx2 and c.916T&gt;C i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Calls as reference or variant by position were graphed to show concordant and discordant genotypes between the two cases. There is a ~15Mb region (green shading) around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dashed line) where there are no apparent discrepancies between the calls, suggesting an inherited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diplotype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block for these two cases who are not known to be related. The AOH seen in case 5 is depicted with flanking dashed lines.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72A55892-F96D-8C98-695E-E76A7EF6D39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483" t="29569" r="289" b="19523"/>
          <a:stretch/>
        </p:blipFill>
        <p:spPr>
          <a:xfrm>
            <a:off x="1826613" y="211796"/>
            <a:ext cx="10095653" cy="1340435"/>
          </a:xfrm>
          <a:prstGeom prst="rect">
            <a:avLst/>
          </a:prstGeom>
          <a:effectLst/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96389BDD-8F9E-A547-B6FB-414C16BE82F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83542" r="385"/>
          <a:stretch/>
        </p:blipFill>
        <p:spPr>
          <a:xfrm>
            <a:off x="1683941" y="1398536"/>
            <a:ext cx="10238325" cy="433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28121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E46FA56-AB26-A045-B245-7ABA9549D6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458" y="371691"/>
            <a:ext cx="5483142" cy="372483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FFE9EDD-AA94-9C42-AEE2-F49706435B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371690"/>
            <a:ext cx="5483142" cy="372483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30E4A2F-6BC6-1342-AE70-22770137C880}"/>
              </a:ext>
            </a:extLst>
          </p:cNvPr>
          <p:cNvSpPr txBox="1"/>
          <p:nvPr/>
        </p:nvSpPr>
        <p:spPr>
          <a:xfrm>
            <a:off x="384039" y="5746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9A4D6D-EF02-2343-83FC-EDE2913760DA}"/>
              </a:ext>
            </a:extLst>
          </p:cNvPr>
          <p:cNvSpPr txBox="1"/>
          <p:nvPr/>
        </p:nvSpPr>
        <p:spPr>
          <a:xfrm>
            <a:off x="6096000" y="55768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898BDDB-58B2-C4CD-7B62-C00298867414}"/>
              </a:ext>
            </a:extLst>
          </p:cNvPr>
          <p:cNvSpPr/>
          <p:nvPr/>
        </p:nvSpPr>
        <p:spPr>
          <a:xfrm>
            <a:off x="379287" y="4574194"/>
            <a:ext cx="9960005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ranched-chain amino acid analysis via dried blood spot at time points 0, 30, 90, 180, and 300 minutes following a 70 mg/kg isoleucine bolus at baseline and repeated after &gt;1 week of thiamine supplementation (B1, 100mg). Amino acid levels are shown as multiples of the local lab upper limit of normal for that amino acid (Val: 190uM, Ile: 91uM, Leu: 160uM)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) A significant reduction in the isoleucine level was not appreciated status post thiamine for cases 7 &amp; 9 who are compound heterozygous for delEx2 and c.916T&gt;C i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) A significant reduction in the isoleucine level was not appreciated status post thiamine for case 12 who is homozygous for c.1261G&gt;T in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DBT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3318153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94408" y="554481"/>
            <a:ext cx="6307334" cy="1801287"/>
            <a:chOff x="3047198" y="2596544"/>
            <a:chExt cx="6408438" cy="2081543"/>
          </a:xfrm>
        </p:grpSpPr>
        <p:sp>
          <p:nvSpPr>
            <p:cNvPr id="5" name="Left Bracket 4"/>
            <p:cNvSpPr/>
            <p:nvPr/>
          </p:nvSpPr>
          <p:spPr>
            <a:xfrm rot="16200000">
              <a:off x="6041344" y="1833659"/>
              <a:ext cx="442090" cy="2745094"/>
            </a:xfrm>
            <a:prstGeom prst="leftBracket">
              <a:avLst>
                <a:gd name="adj" fmla="val 0"/>
              </a:avLst>
            </a:prstGeom>
            <a:solidFill>
              <a:schemeClr val="accent2">
                <a:lumMod val="20000"/>
                <a:lumOff val="80000"/>
              </a:schemeClr>
            </a:solidFill>
            <a:ln w="28575" cmpd="sng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6" name="Rounded Rectangle 5"/>
            <p:cNvSpPr/>
            <p:nvPr/>
          </p:nvSpPr>
          <p:spPr bwMode="auto">
            <a:xfrm>
              <a:off x="4878398" y="3484460"/>
              <a:ext cx="2762922" cy="504459"/>
            </a:xfrm>
            <a:prstGeom prst="roundRect">
              <a:avLst/>
            </a:prstGeom>
            <a:gradFill flip="none" rotWithShape="1">
              <a:gsLst>
                <a:gs pos="0">
                  <a:schemeClr val="accent5">
                    <a:lumMod val="60000"/>
                    <a:lumOff val="40000"/>
                  </a:schemeClr>
                </a:gs>
                <a:gs pos="100000">
                  <a:schemeClr val="accent5">
                    <a:lumMod val="60000"/>
                    <a:lumOff val="40000"/>
                  </a:schemeClr>
                </a:gs>
                <a:gs pos="28000">
                  <a:schemeClr val="bg1">
                    <a:lumMod val="95000"/>
                  </a:schemeClr>
                </a:gs>
                <a:gs pos="79000">
                  <a:schemeClr val="bg1">
                    <a:lumMod val="95000"/>
                  </a:schemeClr>
                </a:gs>
              </a:gsLst>
              <a:lin ang="5400000" scaled="0"/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  <a:latin typeface="Calibri"/>
                <a:ea typeface="ＭＳ Ｐゴシック"/>
                <a:cs typeface="ＭＳ Ｐゴシック"/>
              </a:endParaRPr>
            </a:p>
          </p:txBody>
        </p:sp>
        <p:sp>
          <p:nvSpPr>
            <p:cNvPr id="7" name="TextBox 253"/>
            <p:cNvSpPr txBox="1">
              <a:spLocks noChangeArrowheads="1"/>
            </p:cNvSpPr>
            <p:nvPr/>
          </p:nvSpPr>
          <p:spPr bwMode="auto">
            <a:xfrm>
              <a:off x="3047198" y="2652880"/>
              <a:ext cx="1230876" cy="751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r"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nsport </a:t>
              </a:r>
            </a:p>
            <a:p>
              <a:pPr algn="r"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low</a:t>
              </a:r>
            </a:p>
          </p:txBody>
        </p:sp>
        <p:sp>
          <p:nvSpPr>
            <p:cNvPr id="8" name="Isosceles Triangle 43"/>
            <p:cNvSpPr/>
            <p:nvPr/>
          </p:nvSpPr>
          <p:spPr bwMode="auto">
            <a:xfrm rot="10800000">
              <a:off x="4999588" y="3091944"/>
              <a:ext cx="2453532" cy="271170"/>
            </a:xfrm>
            <a:prstGeom prst="triangle">
              <a:avLst/>
            </a:prstGeom>
            <a:solidFill>
              <a:srgbClr val="EF3E23"/>
            </a:solidFill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rgbClr val="FFA674"/>
                </a:solidFill>
                <a:latin typeface="Calibri"/>
                <a:ea typeface="ＭＳ Ｐゴシック"/>
                <a:cs typeface="ＭＳ Ｐゴシック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5012824" y="2982085"/>
              <a:ext cx="2439404" cy="121000"/>
            </a:xfrm>
            <a:prstGeom prst="rect">
              <a:avLst/>
            </a:prstGeom>
            <a:solidFill>
              <a:srgbClr val="EF3E23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0" name="Left Bracket 9"/>
            <p:cNvSpPr/>
            <p:nvPr/>
          </p:nvSpPr>
          <p:spPr>
            <a:xfrm rot="16200000">
              <a:off x="5621611" y="1843237"/>
              <a:ext cx="1255353" cy="3533046"/>
            </a:xfrm>
            <a:prstGeom prst="leftBracket">
              <a:avLst>
                <a:gd name="adj" fmla="val 0"/>
              </a:avLst>
            </a:prstGeom>
            <a:ln w="57150" cmpd="sng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black"/>
                </a:solidFill>
                <a:latin typeface="Arial"/>
              </a:endParaRPr>
            </a:p>
          </p:txBody>
        </p:sp>
        <p:pic>
          <p:nvPicPr>
            <p:cNvPr id="11" name="Picture 87" descr="D:\kuloth\2014\Feb\14-02-2014\nri_issue\slides_img\nri3623-f2.jpg"/>
            <p:cNvPicPr>
              <a:picLocks noChangeAspect="1" noChangeArrowheads="1"/>
            </p:cNvPicPr>
            <p:nvPr/>
          </p:nvPicPr>
          <p:blipFill rotWithShape="1">
            <a:blip r:embed="rId3" cstate="email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ackgroundRemoval t="0" b="98824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224377" y="3552431"/>
              <a:ext cx="1403175" cy="3569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Picture 87" descr="D:\kuloth\2014\Feb\14-02-2014\nri_issue\slides_img\nri3623-f2.jpg"/>
            <p:cNvPicPr>
              <a:picLocks noChangeAspect="1" noChangeArrowheads="1"/>
            </p:cNvPicPr>
            <p:nvPr/>
          </p:nvPicPr>
          <p:blipFill rotWithShape="1">
            <a:blip r:embed="rId3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ackgroundRemoval t="0" b="97647" l="0" r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4864630" y="3552431"/>
              <a:ext cx="1403175" cy="35693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Rectangle 12"/>
            <p:cNvSpPr/>
            <p:nvPr/>
          </p:nvSpPr>
          <p:spPr>
            <a:xfrm>
              <a:off x="487491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516215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544939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573663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602387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631111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659835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88559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7172839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7460078" y="3423772"/>
              <a:ext cx="190394" cy="57209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white"/>
                </a:solidFill>
                <a:latin typeface="Arial"/>
              </a:endParaRPr>
            </a:p>
          </p:txBody>
        </p:sp>
        <p:sp>
          <p:nvSpPr>
            <p:cNvPr id="23" name="Half Frame 22"/>
            <p:cNvSpPr/>
            <p:nvPr/>
          </p:nvSpPr>
          <p:spPr>
            <a:xfrm rot="5400000">
              <a:off x="4341197" y="2714888"/>
              <a:ext cx="485519" cy="747557"/>
            </a:xfrm>
            <a:prstGeom prst="halfFrame">
              <a:avLst>
                <a:gd name="adj1" fmla="val 6533"/>
                <a:gd name="adj2" fmla="val 4229"/>
              </a:avLst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black"/>
                </a:solidFill>
                <a:latin typeface="Arial"/>
              </a:endParaRPr>
            </a:p>
          </p:txBody>
        </p:sp>
        <p:sp>
          <p:nvSpPr>
            <p:cNvPr id="24" name="Half Frame 23"/>
            <p:cNvSpPr/>
            <p:nvPr/>
          </p:nvSpPr>
          <p:spPr>
            <a:xfrm rot="5400000">
              <a:off x="3811714" y="3346853"/>
              <a:ext cx="1216467" cy="373777"/>
            </a:xfrm>
            <a:prstGeom prst="halfFrame">
              <a:avLst>
                <a:gd name="adj1" fmla="val 3740"/>
                <a:gd name="adj2" fmla="val 4229"/>
              </a:avLst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endParaRPr lang="en-US">
                <a:solidFill>
                  <a:prstClr val="black"/>
                </a:solidFill>
                <a:latin typeface="Arial"/>
              </a:endParaRPr>
            </a:p>
          </p:txBody>
        </p:sp>
        <p:grpSp>
          <p:nvGrpSpPr>
            <p:cNvPr id="25" name="Group 24"/>
            <p:cNvGrpSpPr/>
            <p:nvPr/>
          </p:nvGrpSpPr>
          <p:grpSpPr>
            <a:xfrm flipH="1">
              <a:off x="7551606" y="2845906"/>
              <a:ext cx="747558" cy="1296068"/>
              <a:chOff x="3666585" y="4023245"/>
              <a:chExt cx="747558" cy="1296068"/>
            </a:xfrm>
          </p:grpSpPr>
          <p:sp>
            <p:nvSpPr>
              <p:cNvPr id="34" name="Half Frame 33"/>
              <p:cNvSpPr/>
              <p:nvPr/>
            </p:nvSpPr>
            <p:spPr>
              <a:xfrm rot="5400000">
                <a:off x="3797605" y="3892226"/>
                <a:ext cx="485519" cy="747557"/>
              </a:xfrm>
              <a:prstGeom prst="halfFrame">
                <a:avLst>
                  <a:gd name="adj1" fmla="val 6533"/>
                  <a:gd name="adj2" fmla="val 4229"/>
                </a:avLst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endParaRPr lang="en-US">
                  <a:solidFill>
                    <a:prstClr val="black"/>
                  </a:solidFill>
                  <a:latin typeface="Arial"/>
                </a:endParaRPr>
              </a:p>
            </p:txBody>
          </p:sp>
          <p:sp>
            <p:nvSpPr>
              <p:cNvPr id="35" name="Half Frame 34"/>
              <p:cNvSpPr/>
              <p:nvPr/>
            </p:nvSpPr>
            <p:spPr>
              <a:xfrm rot="5400000">
                <a:off x="3245240" y="4524191"/>
                <a:ext cx="1216467" cy="373777"/>
              </a:xfrm>
              <a:prstGeom prst="halfFrame">
                <a:avLst>
                  <a:gd name="adj1" fmla="val 3740"/>
                  <a:gd name="adj2" fmla="val 4229"/>
                </a:avLst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endParaRPr lang="en-US">
                  <a:solidFill>
                    <a:prstClr val="black"/>
                  </a:solidFill>
                  <a:latin typeface="Arial"/>
                </a:endParaRPr>
              </a:p>
            </p:txBody>
          </p:sp>
        </p:grpSp>
        <p:sp>
          <p:nvSpPr>
            <p:cNvPr id="26" name="TextBox 253"/>
            <p:cNvSpPr txBox="1">
              <a:spLocks noChangeArrowheads="1"/>
            </p:cNvSpPr>
            <p:nvPr/>
          </p:nvSpPr>
          <p:spPr bwMode="auto">
            <a:xfrm>
              <a:off x="8229696" y="2652880"/>
              <a:ext cx="1225940" cy="7510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ansport </a:t>
              </a:r>
            </a:p>
            <a:p>
              <a:pPr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utflow</a:t>
              </a:r>
            </a:p>
          </p:txBody>
        </p:sp>
        <p:cxnSp>
          <p:nvCxnSpPr>
            <p:cNvPr id="27" name="Straight Arrow Connector 26"/>
            <p:cNvCxnSpPr/>
            <p:nvPr/>
          </p:nvCxnSpPr>
          <p:spPr bwMode="auto">
            <a:xfrm>
              <a:off x="7376658" y="3480980"/>
              <a:ext cx="0" cy="302997"/>
            </a:xfrm>
            <a:prstGeom prst="straightConnector1">
              <a:avLst/>
            </a:prstGeom>
            <a:ln w="28575" cap="flat" cmpd="sng">
              <a:solidFill>
                <a:schemeClr val="tx1">
                  <a:lumMod val="75000"/>
                  <a:lumOff val="25000"/>
                </a:schemeClr>
              </a:solidFill>
              <a:prstDash val="solid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 bwMode="auto">
            <a:xfrm>
              <a:off x="6828574" y="3480980"/>
              <a:ext cx="0" cy="304187"/>
            </a:xfrm>
            <a:prstGeom prst="straightConnector1">
              <a:avLst/>
            </a:prstGeom>
            <a:ln w="28575" cap="flat" cmpd="sng">
              <a:solidFill>
                <a:schemeClr val="tx1">
                  <a:lumMod val="75000"/>
                  <a:lumOff val="25000"/>
                </a:schemeClr>
              </a:solidFill>
              <a:prstDash val="solid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 bwMode="auto">
            <a:xfrm>
              <a:off x="5117912" y="3480981"/>
              <a:ext cx="0" cy="304188"/>
            </a:xfrm>
            <a:prstGeom prst="straightConnector1">
              <a:avLst/>
            </a:prstGeom>
            <a:ln w="28575" cap="flat" cmpd="sng">
              <a:solidFill>
                <a:schemeClr val="tx1">
                  <a:lumMod val="75000"/>
                  <a:lumOff val="25000"/>
                </a:schemeClr>
              </a:solidFill>
              <a:prstDash val="solid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/>
            <p:nvPr/>
          </p:nvCxnSpPr>
          <p:spPr bwMode="auto">
            <a:xfrm>
              <a:off x="5684066" y="3480981"/>
              <a:ext cx="0" cy="304189"/>
            </a:xfrm>
            <a:prstGeom prst="straightConnector1">
              <a:avLst/>
            </a:prstGeom>
            <a:ln w="28575" cap="flat" cmpd="sng">
              <a:solidFill>
                <a:schemeClr val="tx1">
                  <a:lumMod val="75000"/>
                  <a:lumOff val="25000"/>
                </a:schemeClr>
              </a:solidFill>
              <a:prstDash val="solid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 bwMode="auto">
            <a:xfrm rot="5400000">
              <a:off x="6244486" y="3552855"/>
              <a:ext cx="0" cy="1088534"/>
            </a:xfrm>
            <a:prstGeom prst="straightConnector1">
              <a:avLst/>
            </a:prstGeom>
            <a:ln w="28575" cap="flat" cmpd="sng">
              <a:solidFill>
                <a:schemeClr val="tx1">
                  <a:lumMod val="75000"/>
                  <a:lumOff val="25000"/>
                </a:schemeClr>
              </a:solidFill>
              <a:prstDash val="solid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253"/>
            <p:cNvSpPr txBox="1">
              <a:spLocks noChangeArrowheads="1"/>
            </p:cNvSpPr>
            <p:nvPr/>
          </p:nvSpPr>
          <p:spPr bwMode="auto">
            <a:xfrm>
              <a:off x="4988089" y="2596544"/>
              <a:ext cx="2563517" cy="462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modynamic Flow</a:t>
              </a:r>
            </a:p>
          </p:txBody>
        </p:sp>
        <p:sp>
          <p:nvSpPr>
            <p:cNvPr id="33" name="TextBox 253"/>
            <p:cNvSpPr txBox="1">
              <a:spLocks noChangeArrowheads="1"/>
            </p:cNvSpPr>
            <p:nvPr/>
          </p:nvSpPr>
          <p:spPr bwMode="auto">
            <a:xfrm>
              <a:off x="5018007" y="4215877"/>
              <a:ext cx="2563517" cy="462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algn="ctr" eaLnBrk="1" fontAlgn="base" hangingPunct="1">
                <a:spcBef>
                  <a:spcPct val="0"/>
                </a:spcBef>
                <a:spcAft>
                  <a:spcPct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terstitial Flow</a:t>
              </a:r>
            </a:p>
          </p:txBody>
        </p:sp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C1F2EFDF-3514-17DA-E2AB-00AD79B328B4}"/>
              </a:ext>
            </a:extLst>
          </p:cNvPr>
          <p:cNvSpPr/>
          <p:nvPr/>
        </p:nvSpPr>
        <p:spPr>
          <a:xfrm>
            <a:off x="774778" y="4264857"/>
            <a:ext cx="9236349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  <a:p>
            <a:pPr marL="342900" indent="-342900">
              <a:buAutoNum type="alphaUcParenR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ketch of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moShea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herapeutics’ hepatocyte bio-reactor. Medium is infused from the infusion port and goes through the upper chamber with the cone (orange triangle which spins) providing for down-ward force on the apical side of the hepatocytes in addition to perfusion through the lower chamber providing horizontal force along the basal side of the hepatocytes. Out-flow is collected by the transport outflow. In these studies, cells are exposed to norm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patocel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edium as well as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patocel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medium enhanced with additional 5 mM leucine, 5 mM isoleucine, and 5 mM valine to recapitulate a decompensation event.</a:t>
            </a:r>
          </a:p>
          <a:p>
            <a:pPr marL="342900" indent="-342900">
              <a:buAutoNum type="alphaUcParenR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mages of hepatocytes in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moShea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herapeutics’ hepatocyte bio-reactor. Slides demonstrate normal structure by immunostaining.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1AA7514E-0952-2851-CC15-3352B38201CB}"/>
              </a:ext>
            </a:extLst>
          </p:cNvPr>
          <p:cNvGrpSpPr/>
          <p:nvPr/>
        </p:nvGrpSpPr>
        <p:grpSpPr>
          <a:xfrm>
            <a:off x="841471" y="2357741"/>
            <a:ext cx="9169656" cy="1666852"/>
            <a:chOff x="1588414" y="1617811"/>
            <a:chExt cx="9169656" cy="1666852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FBD70A24-BBC3-C030-D044-85BAEEBE911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588414" y="1951074"/>
              <a:ext cx="1875725" cy="1333589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36BA628-8295-A1B6-2411-AE224F10E29D}"/>
                </a:ext>
              </a:extLst>
            </p:cNvPr>
            <p:cNvSpPr txBox="1"/>
            <p:nvPr/>
          </p:nvSpPr>
          <p:spPr>
            <a:xfrm>
              <a:off x="2501400" y="3099997"/>
              <a:ext cx="960861" cy="18466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txBody>
            <a:bodyPr wrap="square" lIns="0" tIns="0" rIns="0" bIns="0" rtlCol="0">
              <a:spAutoFit/>
            </a:bodyPr>
            <a:lstStyle/>
            <a:p>
              <a:r>
                <a:rPr lang="en-US" sz="1200" dirty="0">
                  <a:solidFill>
                    <a:srgbClr val="25FF06"/>
                  </a:solidFill>
                  <a:latin typeface="Helvetica Neue Light"/>
                  <a:cs typeface="Helvetica Neue Light"/>
                </a:rPr>
                <a:t>E-cad </a:t>
              </a:r>
              <a:r>
                <a:rPr lang="en-US" sz="1200" b="1" dirty="0">
                  <a:solidFill>
                    <a:srgbClr val="1191FF"/>
                  </a:solidFill>
                  <a:latin typeface="Helvetica Neue Light"/>
                  <a:cs typeface="Helvetica Neue Light"/>
                </a:rPr>
                <a:t>DAPI</a:t>
              </a:r>
              <a:endParaRPr lang="en-US" sz="1200" b="1" dirty="0">
                <a:solidFill>
                  <a:srgbClr val="FFFFFF"/>
                </a:solidFill>
                <a:latin typeface="Helvetica Neue Light"/>
                <a:cs typeface="Helvetica Neue Light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F20BAE1-2DF0-D106-BF30-2C31E55FBAE9}"/>
                </a:ext>
              </a:extLst>
            </p:cNvPr>
            <p:cNvSpPr txBox="1"/>
            <p:nvPr/>
          </p:nvSpPr>
          <p:spPr>
            <a:xfrm>
              <a:off x="1652997" y="1617811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 1</a:t>
              </a:r>
            </a:p>
          </p:txBody>
        </p:sp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993BB383-05C3-CA26-0651-83F6C8F358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t="26028" r="32906" b="24109"/>
            <a:stretch/>
          </p:blipFill>
          <p:spPr>
            <a:xfrm>
              <a:off x="3553002" y="1961566"/>
              <a:ext cx="1780317" cy="1323097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39B4296A-6F05-FD17-06A9-0FEEF45B87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31829" t="10657" r="-1" b="38833"/>
            <a:stretch/>
          </p:blipFill>
          <p:spPr>
            <a:xfrm>
              <a:off x="8949152" y="1944422"/>
              <a:ext cx="1808918" cy="1340241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B4F46803-2979-684E-1692-F9EC2EA8900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8616" t="10381" r="16770" b="39111"/>
            <a:stretch/>
          </p:blipFill>
          <p:spPr>
            <a:xfrm>
              <a:off x="7150927" y="1944422"/>
              <a:ext cx="1714500" cy="1340241"/>
            </a:xfrm>
            <a:prstGeom prst="rect">
              <a:avLst/>
            </a:prstGeom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AB478009-7946-7C58-183B-6757DF878B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8290" t="14395" r="19715" b="35521"/>
            <a:stretch/>
          </p:blipFill>
          <p:spPr>
            <a:xfrm>
              <a:off x="5422182" y="1955731"/>
              <a:ext cx="1645021" cy="1328932"/>
            </a:xfrm>
            <a:prstGeom prst="rect">
              <a:avLst/>
            </a:prstGeom>
          </p:spPr>
        </p:pic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85A88CE-B186-FA21-D59E-134D2EB1245C}"/>
                </a:ext>
              </a:extLst>
            </p:cNvPr>
            <p:cNvSpPr txBox="1"/>
            <p:nvPr/>
          </p:nvSpPr>
          <p:spPr>
            <a:xfrm>
              <a:off x="3618819" y="1617811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F22BA13-F5BB-3295-4F42-4A083FB19BB8}"/>
                </a:ext>
              </a:extLst>
            </p:cNvPr>
            <p:cNvSpPr txBox="1"/>
            <p:nvPr/>
          </p:nvSpPr>
          <p:spPr>
            <a:xfrm>
              <a:off x="8949152" y="1617811"/>
              <a:ext cx="1043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ase 12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ECC76AD-18EB-34AD-E428-4F687766E233}"/>
                </a:ext>
              </a:extLst>
            </p:cNvPr>
            <p:cNvSpPr txBox="1"/>
            <p:nvPr/>
          </p:nvSpPr>
          <p:spPr>
            <a:xfrm>
              <a:off x="7150926" y="1617811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ase 9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0D20C84B-591C-85AA-947B-B3DE6B4DC3C0}"/>
                </a:ext>
              </a:extLst>
            </p:cNvPr>
            <p:cNvSpPr txBox="1"/>
            <p:nvPr/>
          </p:nvSpPr>
          <p:spPr>
            <a:xfrm>
              <a:off x="5450885" y="1617811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ase 5</a:t>
              </a:r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ADC1C31C-A6C2-C909-96BF-7EAB80913355}"/>
              </a:ext>
            </a:extLst>
          </p:cNvPr>
          <p:cNvSpPr txBox="1"/>
          <p:nvPr/>
        </p:nvSpPr>
        <p:spPr>
          <a:xfrm>
            <a:off x="394409" y="7537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526A89-CADB-90D5-9B05-A3C3ABB8AE1D}"/>
              </a:ext>
            </a:extLst>
          </p:cNvPr>
          <p:cNvSpPr txBox="1"/>
          <p:nvPr/>
        </p:nvSpPr>
        <p:spPr>
          <a:xfrm>
            <a:off x="378987" y="2506338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9020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38</Words>
  <Application>Microsoft Office PowerPoint</Application>
  <PresentationFormat>Widescreen</PresentationFormat>
  <Paragraphs>185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Cambria Math</vt:lpstr>
      <vt:lpstr>Courier</vt:lpstr>
      <vt:lpstr>Helvetica Neue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pressed entry</dc:creator>
  <cp:lastModifiedBy>Chapman, Kimberly</cp:lastModifiedBy>
  <cp:revision>2</cp:revision>
  <dcterms:created xsi:type="dcterms:W3CDTF">2022-05-11T14:24:41Z</dcterms:created>
  <dcterms:modified xsi:type="dcterms:W3CDTF">2022-05-12T17:41:40Z</dcterms:modified>
</cp:coreProperties>
</file>